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54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1FA8B9A-D47D-4B52-9BCA-1B9555F31D88}" v="32" dt="2023-08-04T23:31:13.602"/>
    <p1510:client id="{D28BBBFA-84E0-AA73-F329-528E04C3DB9D}" v="45" dt="2023-08-05T06:00:39.47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3784" autoAdjust="0"/>
  </p:normalViewPr>
  <p:slideViewPr>
    <p:cSldViewPr snapToGrid="0">
      <p:cViewPr>
        <p:scale>
          <a:sx n="125" d="100"/>
          <a:sy n="125" d="100"/>
        </p:scale>
        <p:origin x="504" y="-28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築家　恵美" userId="f8a515c7-036c-4132-9fc2-097c41d54ccb" providerId="ADAL" clId="{9E074A82-121E-4AE6-B240-5D6A6796A358}"/>
    <pc:docChg chg="delSld">
      <pc:chgData name="築家　恵美" userId="f8a515c7-036c-4132-9fc2-097c41d54ccb" providerId="ADAL" clId="{9E074A82-121E-4AE6-B240-5D6A6796A358}" dt="2022-05-27T02:14:51.562" v="0" actId="47"/>
      <pc:docMkLst>
        <pc:docMk/>
      </pc:docMkLst>
      <pc:sldChg chg="del">
        <pc:chgData name="築家　恵美" userId="f8a515c7-036c-4132-9fc2-097c41d54ccb" providerId="ADAL" clId="{9E074A82-121E-4AE6-B240-5D6A6796A358}" dt="2022-05-27T02:14:51.562" v="0" actId="47"/>
        <pc:sldMkLst>
          <pc:docMk/>
          <pc:sldMk cId="2656985132" sldId="1545"/>
        </pc:sldMkLst>
      </pc:sldChg>
      <pc:sldChg chg="del">
        <pc:chgData name="築家　恵美" userId="f8a515c7-036c-4132-9fc2-097c41d54ccb" providerId="ADAL" clId="{9E074A82-121E-4AE6-B240-5D6A6796A358}" dt="2022-05-27T02:14:51.562" v="0" actId="47"/>
        <pc:sldMkLst>
          <pc:docMk/>
          <pc:sldMk cId="2851950515" sldId="1547"/>
        </pc:sldMkLst>
      </pc:sldChg>
    </pc:docChg>
  </pc:docChgLst>
  <pc:docChgLst>
    <pc:chgData name="築家　恵美" userId="f8a515c7-036c-4132-9fc2-097c41d54ccb" providerId="ADAL" clId="{6164B3F4-764D-4B0F-8956-69DA9E65C354}"/>
    <pc:docChg chg="undo redo custSel delSld modSld">
      <pc:chgData name="築家　恵美" userId="f8a515c7-036c-4132-9fc2-097c41d54ccb" providerId="ADAL" clId="{6164B3F4-764D-4B0F-8956-69DA9E65C354}" dt="2022-05-06T04:52:51.543" v="595" actId="554"/>
      <pc:docMkLst>
        <pc:docMk/>
      </pc:docMkLst>
      <pc:sldChg chg="del">
        <pc:chgData name="築家　恵美" userId="f8a515c7-036c-4132-9fc2-097c41d54ccb" providerId="ADAL" clId="{6164B3F4-764D-4B0F-8956-69DA9E65C354}" dt="2022-05-06T04:50:20.014" v="592" actId="47"/>
        <pc:sldMkLst>
          <pc:docMk/>
          <pc:sldMk cId="3908323094" sldId="256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2802955094" sldId="258"/>
        </pc:sldMkLst>
      </pc:sldChg>
      <pc:sldChg chg="del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4274357844" sldId="25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3982596869" sldId="263"/>
        </pc:sldMkLst>
        <pc:graphicFrameChg chg="modGraphic">
          <ac:chgData name="築家　恵美" userId="f8a515c7-036c-4132-9fc2-097c41d54ccb" providerId="ADAL" clId="{6164B3F4-764D-4B0F-8956-69DA9E65C354}" dt="2022-05-01T05:59:22.402" v="510" actId="20577"/>
          <ac:graphicFrameMkLst>
            <pc:docMk/>
            <pc:sldMk cId="3982596869" sldId="263"/>
            <ac:graphicFrameMk id="2" creationId="{0823AF79-80AA-4248-85D5-832F9BD2C60A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1582348977" sldId="267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557135690" sldId="26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4175175410" sldId="1541"/>
        </pc:sldMkLst>
        <pc:spChg chg="mod">
          <ac:chgData name="築家　恵美" userId="f8a515c7-036c-4132-9fc2-097c41d54ccb" providerId="ADAL" clId="{6164B3F4-764D-4B0F-8956-69DA9E65C354}" dt="2022-05-01T02:48:10.104" v="111" actId="1076"/>
          <ac:spMkLst>
            <pc:docMk/>
            <pc:sldMk cId="4175175410" sldId="1541"/>
            <ac:spMk id="9" creationId="{6F38D1FA-F836-4904-83E8-A7032747EA31}"/>
          </ac:spMkLst>
        </pc:spChg>
        <pc:spChg chg="mod">
          <ac:chgData name="築家　恵美" userId="f8a515c7-036c-4132-9fc2-097c41d54ccb" providerId="ADAL" clId="{6164B3F4-764D-4B0F-8956-69DA9E65C354}" dt="2022-05-01T02:49:22.075" v="127" actId="1076"/>
          <ac:spMkLst>
            <pc:docMk/>
            <pc:sldMk cId="4175175410" sldId="1541"/>
            <ac:spMk id="12" creationId="{E5290051-5000-41D4-A2CE-A1F5C7EAB5AD}"/>
          </ac:spMkLst>
        </pc:spChg>
        <pc:spChg chg="mod">
          <ac:chgData name="築家　恵美" userId="f8a515c7-036c-4132-9fc2-097c41d54ccb" providerId="ADAL" clId="{6164B3F4-764D-4B0F-8956-69DA9E65C354}" dt="2022-05-01T02:48:33.564" v="113" actId="1076"/>
          <ac:spMkLst>
            <pc:docMk/>
            <pc:sldMk cId="4175175410" sldId="1541"/>
            <ac:spMk id="19" creationId="{90EE9B4A-169E-4314-8B8A-5440D79C75EF}"/>
          </ac:spMkLst>
        </pc:spChg>
        <pc:spChg chg="mod">
          <ac:chgData name="築家　恵美" userId="f8a515c7-036c-4132-9fc2-097c41d54ccb" providerId="ADAL" clId="{6164B3F4-764D-4B0F-8956-69DA9E65C354}" dt="2022-05-01T02:49:07.846" v="116" actId="1076"/>
          <ac:spMkLst>
            <pc:docMk/>
            <pc:sldMk cId="4175175410" sldId="1541"/>
            <ac:spMk id="20" creationId="{53194B26-BB8C-4E12-9B64-4559B1105B98}"/>
          </ac:spMkLst>
        </pc:spChg>
        <pc:spChg chg="mod">
          <ac:chgData name="築家　恵美" userId="f8a515c7-036c-4132-9fc2-097c41d54ccb" providerId="ADAL" clId="{6164B3F4-764D-4B0F-8956-69DA9E65C354}" dt="2022-05-01T02:49:58.661" v="155" actId="1037"/>
          <ac:spMkLst>
            <pc:docMk/>
            <pc:sldMk cId="4175175410" sldId="1541"/>
            <ac:spMk id="45" creationId="{C4426079-3AD7-4033-8DF3-EA8910013D1B}"/>
          </ac:spMkLst>
        </pc:spChg>
        <pc:spChg chg="mod">
          <ac:chgData name="築家　恵美" userId="f8a515c7-036c-4132-9fc2-097c41d54ccb" providerId="ADAL" clId="{6164B3F4-764D-4B0F-8956-69DA9E65C354}" dt="2022-05-01T02:49:53.642" v="140" actId="1038"/>
          <ac:spMkLst>
            <pc:docMk/>
            <pc:sldMk cId="4175175410" sldId="1541"/>
            <ac:spMk id="46" creationId="{0C99492B-F6B9-468D-A280-636F7D1E3666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7" creationId="{89761972-3068-4B26-87F7-AC7A2E4B5FCD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8" creationId="{D7144D86-DC55-4725-8759-4722169393FF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9" creationId="{DF82923F-E100-4CA6-9595-D8F6A218AD75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50" creationId="{E54C0A07-7CF2-48EA-B691-27B221D5C954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4" creationId="{4F5C1735-1F9D-4E01-B59C-CA0EE9CDA7CD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5" creationId="{563C6633-1111-41C8-9A97-A4FEC6C3F7CA}"/>
          </ac:spMkLst>
        </pc:spChg>
        <pc:spChg chg="mod">
          <ac:chgData name="築家　恵美" userId="f8a515c7-036c-4132-9fc2-097c41d54ccb" providerId="ADAL" clId="{6164B3F4-764D-4B0F-8956-69DA9E65C354}" dt="2022-05-01T02:49:13.238" v="126" actId="1036"/>
          <ac:spMkLst>
            <pc:docMk/>
            <pc:sldMk cId="4175175410" sldId="1541"/>
            <ac:spMk id="56" creationId="{FE9EC1C5-0CDC-4D53-A655-E64F970FB736}"/>
          </ac:spMkLst>
        </pc:spChg>
        <pc:graphicFrameChg chg="mod">
          <ac:chgData name="築家　恵美" userId="f8a515c7-036c-4132-9fc2-097c41d54ccb" providerId="ADAL" clId="{6164B3F4-764D-4B0F-8956-69DA9E65C354}" dt="2022-05-01T02:49:37.966" v="131" actId="1076"/>
          <ac:graphicFrameMkLst>
            <pc:docMk/>
            <pc:sldMk cId="4175175410" sldId="1541"/>
            <ac:graphicFrameMk id="22" creationId="{FAAB50DF-4799-45B7-A149-634EBE36B0A3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23" creationId="{CFD31A72-C4EC-41A5-98A5-0FF6EE0B3ED6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33" creationId="{CFD31A72-C4EC-41A5-98A5-0FF6EE0B3ED6}"/>
          </ac:graphicFrameMkLst>
        </pc:graphicFrameChg>
        <pc:cxnChg chg="mod">
          <ac:chgData name="築家　恵美" userId="f8a515c7-036c-4132-9fc2-097c41d54ccb" providerId="ADAL" clId="{6164B3F4-764D-4B0F-8956-69DA9E65C354}" dt="2022-05-01T02:49:22.075" v="127" actId="1076"/>
          <ac:cxnSpMkLst>
            <pc:docMk/>
            <pc:sldMk cId="4175175410" sldId="1541"/>
            <ac:cxnSpMk id="8" creationId="{67665785-685A-4226-B5AB-94E635E9CFE5}"/>
          </ac:cxnSpMkLst>
        </pc:cxnChg>
      </pc:sldChg>
      <pc:sldChg chg="modSp mod modNotesTx">
        <pc:chgData name="築家　恵美" userId="f8a515c7-036c-4132-9fc2-097c41d54ccb" providerId="ADAL" clId="{6164B3F4-764D-4B0F-8956-69DA9E65C354}" dt="2022-05-01T04:44:19.551" v="499" actId="1076"/>
        <pc:sldMkLst>
          <pc:docMk/>
          <pc:sldMk cId="2737564786" sldId="1544"/>
        </pc:sldMkLst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" creationId="{AAB447A1-2784-4E6C-B313-4ABA3B863C89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" creationId="{35A9C8DC-D6FE-4AC6-81EF-BD99AD8BAD28}"/>
          </ac:spMkLst>
        </pc:spChg>
        <pc:spChg chg="mod">
          <ac:chgData name="築家　恵美" userId="f8a515c7-036c-4132-9fc2-097c41d54ccb" providerId="ADAL" clId="{6164B3F4-764D-4B0F-8956-69DA9E65C354}" dt="2022-05-01T04:43:21.609" v="483" actId="1037"/>
          <ac:spMkLst>
            <pc:docMk/>
            <pc:sldMk cId="2737564786" sldId="1544"/>
            <ac:spMk id="23" creationId="{4EAADF5A-E106-4677-888D-D7DA03805A5C}"/>
          </ac:spMkLst>
        </pc:spChg>
        <pc:spChg chg="mod">
          <ac:chgData name="築家　恵美" userId="f8a515c7-036c-4132-9fc2-097c41d54ccb" providerId="ADAL" clId="{6164B3F4-764D-4B0F-8956-69DA9E65C354}" dt="2022-05-01T04:42:44.754" v="467" actId="1038"/>
          <ac:spMkLst>
            <pc:docMk/>
            <pc:sldMk cId="2737564786" sldId="1544"/>
            <ac:spMk id="24" creationId="{F2C73E29-822F-4869-99BB-9FE151171E63}"/>
          </ac:spMkLst>
        </pc:spChg>
        <pc:spChg chg="mod">
          <ac:chgData name="築家　恵美" userId="f8a515c7-036c-4132-9fc2-097c41d54ccb" providerId="ADAL" clId="{6164B3F4-764D-4B0F-8956-69DA9E65C354}" dt="2022-05-01T04:43:26.560" v="487" actId="1038"/>
          <ac:spMkLst>
            <pc:docMk/>
            <pc:sldMk cId="2737564786" sldId="1544"/>
            <ac:spMk id="25" creationId="{39629508-9385-4E23-A8A2-E8A3D7329ABE}"/>
          </ac:spMkLst>
        </pc:spChg>
        <pc:spChg chg="mod">
          <ac:chgData name="築家　恵美" userId="f8a515c7-036c-4132-9fc2-097c41d54ccb" providerId="ADAL" clId="{6164B3F4-764D-4B0F-8956-69DA9E65C354}" dt="2022-05-01T04:42:49.984" v="475" actId="1037"/>
          <ac:spMkLst>
            <pc:docMk/>
            <pc:sldMk cId="2737564786" sldId="1544"/>
            <ac:spMk id="26" creationId="{566A6F51-AA85-4E79-96A3-73983FF29AFC}"/>
          </ac:spMkLst>
        </pc:spChg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築家　恵美" userId="f8a515c7-036c-4132-9fc2-097c41d54ccb" providerId="ADAL" clId="{6164B3F4-764D-4B0F-8956-69DA9E65C354}" dt="2022-05-01T04:43:57.374" v="497" actId="1076"/>
          <ac:spMkLst>
            <pc:docMk/>
            <pc:sldMk cId="2737564786" sldId="1544"/>
            <ac:spMk id="28" creationId="{E87F0079-DEDD-421B-8671-72B7415D8475}"/>
          </ac:spMkLst>
        </pc:spChg>
        <pc:spChg chg="mod">
          <ac:chgData name="築家　恵美" userId="f8a515c7-036c-4132-9fc2-097c41d54ccb" providerId="ADAL" clId="{6164B3F4-764D-4B0F-8956-69DA9E65C354}" dt="2022-05-01T04:43:52.136" v="496" actId="1076"/>
          <ac:spMkLst>
            <pc:docMk/>
            <pc:sldMk cId="2737564786" sldId="1544"/>
            <ac:spMk id="29" creationId="{684B3255-9DF0-47E5-AC29-22EAED094B5A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3" creationId="{DAA9116E-35F6-4632-A8BC-E1B4EA55F83A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4" creationId="{1A144062-55D0-49E9-A9C4-074C36101BC0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5" creationId="{11FE1617-F8C2-45BC-BEE9-EB606305D068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6" creationId="{8122FBE5-94BB-44A3-A972-B178007D01ED}"/>
          </ac:spMkLst>
        </pc:sp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5" creationId="{59AB4315-01AB-437A-B29D-9901264C81FB}"/>
          </ac:picMkLst>
        </pc:pic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6" creationId="{E84D135F-2565-4B9B-8977-75E4F3088D15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7" creationId="{A58F503C-89E5-418C-BB21-6F282F5ECB9E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13" creationId="{70026DAB-78A9-4C96-B357-439813CDC28E}"/>
          </ac:picMkLst>
        </pc:pic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2" creationId="{266CDAD2-3712-4213-B697-20E4771F911D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4" creationId="{03365C0D-930B-401B-BA91-A1BC730C08A3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5" creationId="{94472C14-F3A9-40A8-B9C9-EA7026410631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6" creationId="{17B81A3E-20A0-433E-942E-EDA82C0F5CC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7" creationId="{30B8C6A5-90C9-4F90-B9D6-9A556323C06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8" creationId="{9A2E005D-B84B-4019-A404-E2D47BF0DBEF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22" creationId="{9A255FB2-CB5B-4219-B93A-78AF46D1EE6C}"/>
          </ac:cxnSpMkLst>
        </pc:cxnChg>
      </pc:sldChg>
      <pc:sldChg chg="addSp modSp mod modNotesTx">
        <pc:chgData name="築家　恵美" userId="f8a515c7-036c-4132-9fc2-097c41d54ccb" providerId="ADAL" clId="{6164B3F4-764D-4B0F-8956-69DA9E65C354}" dt="2022-05-01T06:12:28.532" v="590" actId="554"/>
        <pc:sldMkLst>
          <pc:docMk/>
          <pc:sldMk cId="2656985132" sldId="1545"/>
        </pc:sldMkLst>
        <pc:spChg chg="mod">
          <ac:chgData name="築家　恵美" userId="f8a515c7-036c-4132-9fc2-097c41d54ccb" providerId="ADAL" clId="{6164B3F4-764D-4B0F-8956-69DA9E65C354}" dt="2022-05-01T06:11:56.528" v="547" actId="1076"/>
          <ac:spMkLst>
            <pc:docMk/>
            <pc:sldMk cId="2656985132" sldId="1545"/>
            <ac:spMk id="7" creationId="{42BD6D29-446B-4228-AE46-2D01FC226AD6}"/>
          </ac:spMkLst>
        </pc:spChg>
        <pc:spChg chg="mod">
          <ac:chgData name="築家　恵美" userId="f8a515c7-036c-4132-9fc2-097c41d54ccb" providerId="ADAL" clId="{6164B3F4-764D-4B0F-8956-69DA9E65C354}" dt="2022-05-01T06:12:09.129" v="553" actId="1037"/>
          <ac:spMkLst>
            <pc:docMk/>
            <pc:sldMk cId="2656985132" sldId="1545"/>
            <ac:spMk id="8" creationId="{9F81EEDC-66A2-4329-98F8-FDA379229655}"/>
          </ac:spMkLst>
        </pc:spChg>
        <pc:spChg chg="mod">
          <ac:chgData name="築家　恵美" userId="f8a515c7-036c-4132-9fc2-097c41d54ccb" providerId="ADAL" clId="{6164B3F4-764D-4B0F-8956-69DA9E65C354}" dt="2022-05-01T06:11:48.038" v="545" actId="1076"/>
          <ac:spMkLst>
            <pc:docMk/>
            <pc:sldMk cId="2656985132" sldId="1545"/>
            <ac:spMk id="9" creationId="{697954D4-0455-43E7-A767-DF072C96BDEB}"/>
          </ac:spMkLst>
        </pc:spChg>
        <pc:spChg chg="mod">
          <ac:chgData name="築家　恵美" userId="f8a515c7-036c-4132-9fc2-097c41d54ccb" providerId="ADAL" clId="{6164B3F4-764D-4B0F-8956-69DA9E65C354}" dt="2022-05-01T06:11:53.468" v="546" actId="1076"/>
          <ac:spMkLst>
            <pc:docMk/>
            <pc:sldMk cId="2656985132" sldId="1545"/>
            <ac:spMk id="10" creationId="{57D07C43-9C2E-43BC-8926-276B9D9FBDF0}"/>
          </ac:spMkLst>
        </pc:spChg>
        <pc:spChg chg="mod">
          <ac:chgData name="築家　恵美" userId="f8a515c7-036c-4132-9fc2-097c41d54ccb" providerId="ADAL" clId="{6164B3F4-764D-4B0F-8956-69DA9E65C354}" dt="2022-05-01T06:11:36.849" v="542" actId="1076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6164B3F4-764D-4B0F-8956-69DA9E65C354}" dt="2022-05-01T06:11:42.146" v="544" actId="1076"/>
          <ac:spMkLst>
            <pc:docMk/>
            <pc:sldMk cId="2656985132" sldId="1545"/>
            <ac:spMk id="12" creationId="{2ACB7089-FD64-4D49-9AE4-8CA6F0C353D7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3" creationId="{92AE953E-F678-4595-B14E-4E30BEAC5994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4" creationId="{22BCE159-5115-4B9E-A592-7A8A9C8537FE}"/>
          </ac:spMkLst>
        </pc:sp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5" creationId="{F2C967B2-17C4-452C-9CB3-B2E11D88C0BE}"/>
          </ac:graphicFrameMkLst>
        </pc:graphicFrameChg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2795708836" sldId="1546"/>
        </pc:sldMkLst>
        <pc:spChg chg="mod">
          <ac:chgData name="築家　恵美" userId="f8a515c7-036c-4132-9fc2-097c41d54ccb" providerId="ADAL" clId="{6164B3F4-764D-4B0F-8956-69DA9E65C354}" dt="2022-05-01T02:51:41.978" v="238" actId="1076"/>
          <ac:spMkLst>
            <pc:docMk/>
            <pc:sldMk cId="2795708836" sldId="1546"/>
            <ac:spMk id="4" creationId="{2E06A803-9CA0-4D84-8AE7-3C00140A94E9}"/>
          </ac:spMkLst>
        </pc:spChg>
        <pc:spChg chg="mod">
          <ac:chgData name="築家　恵美" userId="f8a515c7-036c-4132-9fc2-097c41d54ccb" providerId="ADAL" clId="{6164B3F4-764D-4B0F-8956-69DA9E65C354}" dt="2022-05-01T02:51:16.513" v="235" actId="255"/>
          <ac:spMkLst>
            <pc:docMk/>
            <pc:sldMk cId="2795708836" sldId="1546"/>
            <ac:spMk id="7" creationId="{5E76C1B8-0381-4750-B60C-E35A0F16546A}"/>
          </ac:spMkLst>
        </pc:spChg>
        <pc:spChg chg="mod">
          <ac:chgData name="築家　恵美" userId="f8a515c7-036c-4132-9fc2-097c41d54ccb" providerId="ADAL" clId="{6164B3F4-764D-4B0F-8956-69DA9E65C354}" dt="2022-05-01T02:51:50.345" v="239" actId="1076"/>
          <ac:spMkLst>
            <pc:docMk/>
            <pc:sldMk cId="2795708836" sldId="1546"/>
            <ac:spMk id="13" creationId="{0D1FDBAE-E7C8-4821-BB9E-21F43D7D0669}"/>
          </ac:spMkLst>
        </pc:spChg>
        <pc:graphicFrameChg chg="mod">
          <ac:chgData name="築家　恵美" userId="f8a515c7-036c-4132-9fc2-097c41d54ccb" providerId="ADAL" clId="{6164B3F4-764D-4B0F-8956-69DA9E65C354}" dt="2022-05-01T02:51:29.504" v="237" actId="2711"/>
          <ac:graphicFrameMkLst>
            <pc:docMk/>
            <pc:sldMk cId="2795708836" sldId="1546"/>
            <ac:graphicFrameMk id="2" creationId="{3166DEDD-1A1C-4AD6-BC5C-5A2A720B9DCC}"/>
          </ac:graphicFrameMkLst>
        </pc:graphicFrameChg>
      </pc:sldChg>
      <pc:sldChg chg="modSp mod modNotesTx">
        <pc:chgData name="築家　恵美" userId="f8a515c7-036c-4132-9fc2-097c41d54ccb" providerId="ADAL" clId="{6164B3F4-764D-4B0F-8956-69DA9E65C354}" dt="2022-05-06T04:52:51.543" v="595" actId="554"/>
        <pc:sldMkLst>
          <pc:docMk/>
          <pc:sldMk cId="2851950515" sldId="1547"/>
        </pc:sldMkLst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築家　恵美" userId="f8a515c7-036c-4132-9fc2-097c41d54ccb" providerId="ADAL" clId="{6164B3F4-764D-4B0F-8956-69DA9E65C354}" dt="2022-05-01T06:09:00.008" v="527" actId="1036"/>
          <ac:spMkLst>
            <pc:docMk/>
            <pc:sldMk cId="2851950515" sldId="1547"/>
            <ac:spMk id="7" creationId="{37F7D5CF-F508-41E9-9F90-E00439CC1A4F}"/>
          </ac:spMkLst>
        </pc:spChg>
        <pc:spChg chg="mod">
          <ac:chgData name="築家　恵美" userId="f8a515c7-036c-4132-9fc2-097c41d54ccb" providerId="ADAL" clId="{6164B3F4-764D-4B0F-8956-69DA9E65C354}" dt="2022-05-01T06:09:37.713" v="534" actId="1076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築家　恵美" userId="f8a515c7-036c-4132-9fc2-097c41d54ccb" providerId="ADAL" clId="{6164B3F4-764D-4B0F-8956-69DA9E65C354}" dt="2022-05-01T06:09:29.262" v="533" actId="1076"/>
          <ac:spMkLst>
            <pc:docMk/>
            <pc:sldMk cId="2851950515" sldId="1547"/>
            <ac:spMk id="9" creationId="{7B1777C7-5112-44A2-9F2B-5C50DDD4B3DA}"/>
          </ac:spMkLst>
        </pc:spChg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10" creationId="{7A3DBBF8-AE95-4DC1-A405-7F893F4609FF}"/>
          </ac:spMkLst>
        </pc:spChg>
        <pc:spChg chg="mod">
          <ac:chgData name="築家　恵美" userId="f8a515c7-036c-4132-9fc2-097c41d54ccb" providerId="ADAL" clId="{6164B3F4-764D-4B0F-8956-69DA9E65C354}" dt="2022-05-01T06:08:42.178" v="522" actId="1076"/>
          <ac:spMkLst>
            <pc:docMk/>
            <pc:sldMk cId="2851950515" sldId="1547"/>
            <ac:spMk id="11" creationId="{56ED5E6C-86B9-4BCB-B208-A58B16C77D52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6164B3F4-764D-4B0F-8956-69DA9E65C354}" dt="2022-05-01T06:08:29.864" v="520" actId="1076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6164B3F4-764D-4B0F-8956-69DA9E65C354}" dt="2022-05-01T06:09:12.157" v="529" actId="1076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6164B3F4-764D-4B0F-8956-69DA9E65C354}" dt="2022-05-01T06:09:07.162" v="528" actId="1076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6164B3F4-764D-4B0F-8956-69DA9E65C354}" dt="2022-05-01T06:09:17.601" v="530" actId="1076"/>
          <ac:spMkLst>
            <pc:docMk/>
            <pc:sldMk cId="2851950515" sldId="1547"/>
            <ac:spMk id="17" creationId="{5EFCC239-C17A-4E6B-8B2C-186D783DA2B1}"/>
          </ac:spMkLst>
        </pc:spChg>
        <pc:graphicFrameChg chg="mod">
          <ac:chgData name="築家　恵美" userId="f8a515c7-036c-4132-9fc2-097c41d54ccb" providerId="ADAL" clId="{6164B3F4-764D-4B0F-8956-69DA9E65C354}" dt="2022-05-01T06:07:48.672" v="513" actId="1076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5" creationId="{F2C967B2-17C4-452C-9CB3-B2E11D88C0BE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3101292763" sldId="1548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12454413" sldId="1549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3625042175" sldId="1550"/>
        </pc:sldMkLst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1992467510" sldId="1551"/>
        </pc:sldMkLst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2" creationId="{71B7F480-A674-4D40-A9D9-0097F6FD8BA1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3" creationId="{5AAF28F2-6F7D-481F-A027-2E1224192A93}"/>
          </ac:spMkLst>
        </pc:spChg>
        <pc:spChg chg="mod">
          <ac:chgData name="築家　恵美" userId="f8a515c7-036c-4132-9fc2-097c41d54ccb" providerId="ADAL" clId="{6164B3F4-764D-4B0F-8956-69DA9E65C354}" dt="2022-05-01T01:54:54.518" v="12" actId="1036"/>
          <ac:spMkLst>
            <pc:docMk/>
            <pc:sldMk cId="1992467510" sldId="1551"/>
            <ac:spMk id="4" creationId="{27D4127C-B955-4360-B442-0F9925CA6CFA}"/>
          </ac:spMkLst>
        </pc:spChg>
        <pc:spChg chg="mod">
          <ac:chgData name="築家　恵美" userId="f8a515c7-036c-4132-9fc2-097c41d54ccb" providerId="ADAL" clId="{6164B3F4-764D-4B0F-8956-69DA9E65C354}" dt="2022-05-01T01:54:59.427" v="15" actId="1035"/>
          <ac:spMkLst>
            <pc:docMk/>
            <pc:sldMk cId="1992467510" sldId="1551"/>
            <ac:spMk id="5" creationId="{AE8C8A7A-66E7-48C4-BEE7-AF5621784AF5}"/>
          </ac:spMkLst>
        </pc:spChg>
        <pc:spChg chg="mod">
          <ac:chgData name="築家　恵美" userId="f8a515c7-036c-4132-9fc2-097c41d54ccb" providerId="ADAL" clId="{6164B3F4-764D-4B0F-8956-69DA9E65C354}" dt="2022-05-01T01:55:25.171" v="59" actId="1038"/>
          <ac:spMkLst>
            <pc:docMk/>
            <pc:sldMk cId="1992467510" sldId="1551"/>
            <ac:spMk id="6" creationId="{5EE7BD52-E269-48A7-8B7F-816E9CADADAD}"/>
          </ac:spMkLst>
        </pc:spChg>
        <pc:spChg chg="mod">
          <ac:chgData name="築家　恵美" userId="f8a515c7-036c-4132-9fc2-097c41d54ccb" providerId="ADAL" clId="{6164B3F4-764D-4B0F-8956-69DA9E65C354}" dt="2022-05-01T01:55:12.222" v="25" actId="1035"/>
          <ac:spMkLst>
            <pc:docMk/>
            <pc:sldMk cId="1992467510" sldId="1551"/>
            <ac:spMk id="7" creationId="{B490BF6A-E72B-4207-BB13-7D8C67D60184}"/>
          </ac:spMkLst>
        </pc:spChg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8" creationId="{0EA92D96-1438-4E7E-B423-4BC09C7960B8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9" creationId="{FD8030E1-B02C-4664-B64A-F58F89CA874F}"/>
          </ac:spMkLst>
        </pc:spChg>
        <pc:graphicFrameChg chg="mod">
          <ac:chgData name="築家　恵美" userId="f8a515c7-036c-4132-9fc2-097c41d54ccb" providerId="ADAL" clId="{6164B3F4-764D-4B0F-8956-69DA9E65C354}" dt="2022-05-01T01:54:04.496" v="1" actId="1076"/>
          <ac:graphicFrameMkLst>
            <pc:docMk/>
            <pc:sldMk cId="1992467510" sldId="1551"/>
            <ac:graphicFrameMk id="10" creationId="{EF7BB7D3-E073-480E-88D9-60BB107875F1}"/>
          </ac:graphicFrameMkLst>
        </pc:graphicFrameChg>
        <pc:graphicFrameChg chg="mod">
          <ac:chgData name="築家　恵美" userId="f8a515c7-036c-4132-9fc2-097c41d54ccb" providerId="ADAL" clId="{6164B3F4-764D-4B0F-8956-69DA9E65C354}" dt="2022-05-01T01:54:15.825" v="2" actId="1076"/>
          <ac:graphicFrameMkLst>
            <pc:docMk/>
            <pc:sldMk cId="1992467510" sldId="1551"/>
            <ac:graphicFrameMk id="11" creationId="{34395CA2-0E34-471E-B763-11F858A291E8}"/>
          </ac:graphicFrameMkLst>
        </pc:graphicFrameChg>
      </pc:sldChg>
    </pc:docChg>
  </pc:docChgLst>
  <pc:docChgLst>
    <pc:chgData name="築家　恵美" userId="f8a515c7-036c-4132-9fc2-097c41d54ccb" providerId="ADAL" clId="{81FA8B9A-D47D-4B52-9BCA-1B9555F31D88}"/>
    <pc:docChg chg="undo custSel modSld">
      <pc:chgData name="築家　恵美" userId="f8a515c7-036c-4132-9fc2-097c41d54ccb" providerId="ADAL" clId="{81FA8B9A-D47D-4B52-9BCA-1B9555F31D88}" dt="2023-08-04T23:32:19.831" v="801" actId="1035"/>
      <pc:docMkLst>
        <pc:docMk/>
      </pc:docMkLst>
      <pc:sldChg chg="addSp delSp modSp mod modNotesTx">
        <pc:chgData name="築家　恵美" userId="f8a515c7-036c-4132-9fc2-097c41d54ccb" providerId="ADAL" clId="{81FA8B9A-D47D-4B52-9BCA-1B9555F31D88}" dt="2023-08-04T23:32:19.831" v="801" actId="1035"/>
        <pc:sldMkLst>
          <pc:docMk/>
          <pc:sldMk cId="2737564786" sldId="1544"/>
        </pc:sldMkLst>
        <pc:spChg chg="mod">
          <ac:chgData name="築家　恵美" userId="f8a515c7-036c-4132-9fc2-097c41d54ccb" providerId="ADAL" clId="{81FA8B9A-D47D-4B52-9BCA-1B9555F31D88}" dt="2023-07-31T05:47:12.191" v="681" actId="1038"/>
          <ac:spMkLst>
            <pc:docMk/>
            <pc:sldMk cId="2737564786" sldId="1544"/>
            <ac:spMk id="2" creationId="{AAB447A1-2784-4E6C-B313-4ABA3B863C89}"/>
          </ac:spMkLst>
        </pc:spChg>
        <pc:spChg chg="mod">
          <ac:chgData name="築家　恵美" userId="f8a515c7-036c-4132-9fc2-097c41d54ccb" providerId="ADAL" clId="{81FA8B9A-D47D-4B52-9BCA-1B9555F31D88}" dt="2023-07-31T05:46:52.586" v="674" actId="1076"/>
          <ac:spMkLst>
            <pc:docMk/>
            <pc:sldMk cId="2737564786" sldId="1544"/>
            <ac:spMk id="3" creationId="{35A9C8DC-D6FE-4AC6-81EF-BD99AD8BAD28}"/>
          </ac:spMkLst>
        </pc:spChg>
        <pc:spChg chg="add mod">
          <ac:chgData name="築家　恵美" userId="f8a515c7-036c-4132-9fc2-097c41d54ccb" providerId="ADAL" clId="{81FA8B9A-D47D-4B52-9BCA-1B9555F31D88}" dt="2023-07-31T05:36:47.802" v="533" actId="1038"/>
          <ac:spMkLst>
            <pc:docMk/>
            <pc:sldMk cId="2737564786" sldId="1544"/>
            <ac:spMk id="4" creationId="{8C00F2C5-E75B-09EA-D342-0C1D519A1F3B}"/>
          </ac:spMkLst>
        </pc:spChg>
        <pc:spChg chg="add mod">
          <ac:chgData name="築家　恵美" userId="f8a515c7-036c-4132-9fc2-097c41d54ccb" providerId="ADAL" clId="{81FA8B9A-D47D-4B52-9BCA-1B9555F31D88}" dt="2023-07-25T03:43:53.376" v="36" actId="14100"/>
          <ac:spMkLst>
            <pc:docMk/>
            <pc:sldMk cId="2737564786" sldId="1544"/>
            <ac:spMk id="10" creationId="{CDB28F7F-586C-BF05-2F29-5D11A2B72757}"/>
          </ac:spMkLst>
        </pc:spChg>
        <pc:spChg chg="add mod">
          <ac:chgData name="築家　恵美" userId="f8a515c7-036c-4132-9fc2-097c41d54ccb" providerId="ADAL" clId="{81FA8B9A-D47D-4B52-9BCA-1B9555F31D88}" dt="2023-07-31T05:58:17.420" v="783" actId="552"/>
          <ac:spMkLst>
            <pc:docMk/>
            <pc:sldMk cId="2737564786" sldId="1544"/>
            <ac:spMk id="11" creationId="{DA1F331C-4FAD-E3DD-B164-4F72297F9B15}"/>
          </ac:spMkLst>
        </pc:spChg>
        <pc:spChg chg="add mod">
          <ac:chgData name="築家　恵美" userId="f8a515c7-036c-4132-9fc2-097c41d54ccb" providerId="ADAL" clId="{81FA8B9A-D47D-4B52-9BCA-1B9555F31D88}" dt="2023-07-31T05:58:17.420" v="783" actId="552"/>
          <ac:spMkLst>
            <pc:docMk/>
            <pc:sldMk cId="2737564786" sldId="1544"/>
            <ac:spMk id="17" creationId="{F6F6790B-F0E2-FB69-EE6F-D9316F095EA8}"/>
          </ac:spMkLst>
        </pc:spChg>
        <pc:spChg chg="add mod">
          <ac:chgData name="築家　恵美" userId="f8a515c7-036c-4132-9fc2-097c41d54ccb" providerId="ADAL" clId="{81FA8B9A-D47D-4B52-9BCA-1B9555F31D88}" dt="2023-07-31T05:58:17.420" v="783" actId="552"/>
          <ac:spMkLst>
            <pc:docMk/>
            <pc:sldMk cId="2737564786" sldId="1544"/>
            <ac:spMk id="18" creationId="{B780783F-F40C-B950-5914-05E9548F742D}"/>
          </ac:spMkLst>
        </pc:spChg>
        <pc:spChg chg="mod">
          <ac:chgData name="築家　恵美" userId="f8a515c7-036c-4132-9fc2-097c41d54ccb" providerId="ADAL" clId="{81FA8B9A-D47D-4B52-9BCA-1B9555F31D88}" dt="2023-07-31T05:34:40.645" v="452" actId="12788"/>
          <ac:spMkLst>
            <pc:docMk/>
            <pc:sldMk cId="2737564786" sldId="1544"/>
            <ac:spMk id="23" creationId="{4EAADF5A-E106-4677-888D-D7DA03805A5C}"/>
          </ac:spMkLst>
        </pc:spChg>
        <pc:spChg chg="mod">
          <ac:chgData name="築家　恵美" userId="f8a515c7-036c-4132-9fc2-097c41d54ccb" providerId="ADAL" clId="{81FA8B9A-D47D-4B52-9BCA-1B9555F31D88}" dt="2023-07-31T05:48:08.945" v="717" actId="1037"/>
          <ac:spMkLst>
            <pc:docMk/>
            <pc:sldMk cId="2737564786" sldId="1544"/>
            <ac:spMk id="24" creationId="{F2C73E29-822F-4869-99BB-9FE151171E63}"/>
          </ac:spMkLst>
        </pc:spChg>
        <pc:spChg chg="mod">
          <ac:chgData name="築家　恵美" userId="f8a515c7-036c-4132-9fc2-097c41d54ccb" providerId="ADAL" clId="{81FA8B9A-D47D-4B52-9BCA-1B9555F31D88}" dt="2023-07-31T05:37:55.829" v="544" actId="1076"/>
          <ac:spMkLst>
            <pc:docMk/>
            <pc:sldMk cId="2737564786" sldId="1544"/>
            <ac:spMk id="25" creationId="{39629508-9385-4E23-A8A2-E8A3D7329ABE}"/>
          </ac:spMkLst>
        </pc:spChg>
        <pc:spChg chg="mod">
          <ac:chgData name="築家　恵美" userId="f8a515c7-036c-4132-9fc2-097c41d54ccb" providerId="ADAL" clId="{81FA8B9A-D47D-4B52-9BCA-1B9555F31D88}" dt="2023-07-31T05:48:00.417" v="700" actId="554"/>
          <ac:spMkLst>
            <pc:docMk/>
            <pc:sldMk cId="2737564786" sldId="1544"/>
            <ac:spMk id="26" creationId="{566A6F51-AA85-4E79-96A3-73983FF29AFC}"/>
          </ac:spMkLst>
        </pc:spChg>
        <pc:spChg chg="mod">
          <ac:chgData name="築家　恵美" userId="f8a515c7-036c-4132-9fc2-097c41d54ccb" providerId="ADAL" clId="{81FA8B9A-D47D-4B52-9BCA-1B9555F31D88}" dt="2023-07-31T05:37:39.854" v="543" actId="554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築家　恵美" userId="f8a515c7-036c-4132-9fc2-097c41d54ccb" providerId="ADAL" clId="{81FA8B9A-D47D-4B52-9BCA-1B9555F31D88}" dt="2023-07-31T05:47:30.922" v="696" actId="1038"/>
          <ac:spMkLst>
            <pc:docMk/>
            <pc:sldMk cId="2737564786" sldId="1544"/>
            <ac:spMk id="28" creationId="{E87F0079-DEDD-421B-8671-72B7415D8475}"/>
          </ac:spMkLst>
        </pc:spChg>
        <pc:spChg chg="mod">
          <ac:chgData name="築家　恵美" userId="f8a515c7-036c-4132-9fc2-097c41d54ccb" providerId="ADAL" clId="{81FA8B9A-D47D-4B52-9BCA-1B9555F31D88}" dt="2023-07-31T05:37:39.854" v="543" actId="554"/>
          <ac:spMkLst>
            <pc:docMk/>
            <pc:sldMk cId="2737564786" sldId="1544"/>
            <ac:spMk id="29" creationId="{684B3255-9DF0-47E5-AC29-22EAED094B5A}"/>
          </ac:spMkLst>
        </pc:spChg>
        <pc:spChg chg="mod">
          <ac:chgData name="築家　恵美" userId="f8a515c7-036c-4132-9fc2-097c41d54ccb" providerId="ADAL" clId="{81FA8B9A-D47D-4B52-9BCA-1B9555F31D88}" dt="2023-07-31T05:46:42.242" v="672" actId="1076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築家　恵美" userId="f8a515c7-036c-4132-9fc2-097c41d54ccb" providerId="ADAL" clId="{81FA8B9A-D47D-4B52-9BCA-1B9555F31D88}" dt="2023-07-31T05:49:22.508" v="742" actId="1037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築家　恵美" userId="f8a515c7-036c-4132-9fc2-097c41d54ccb" providerId="ADAL" clId="{81FA8B9A-D47D-4B52-9BCA-1B9555F31D88}" dt="2023-07-31T05:49:22.508" v="742" actId="1037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築家　恵美" userId="f8a515c7-036c-4132-9fc2-097c41d54ccb" providerId="ADAL" clId="{81FA8B9A-D47D-4B52-9BCA-1B9555F31D88}" dt="2023-07-25T03:43:37.338" v="35" actId="554"/>
          <ac:spMkLst>
            <pc:docMk/>
            <pc:sldMk cId="2737564786" sldId="1544"/>
            <ac:spMk id="33" creationId="{DAA9116E-35F6-4632-A8BC-E1B4EA55F83A}"/>
          </ac:spMkLst>
        </pc:spChg>
        <pc:spChg chg="mod">
          <ac:chgData name="築家　恵美" userId="f8a515c7-036c-4132-9fc2-097c41d54ccb" providerId="ADAL" clId="{81FA8B9A-D47D-4B52-9BCA-1B9555F31D88}" dt="2023-07-25T03:43:37.338" v="35" actId="554"/>
          <ac:spMkLst>
            <pc:docMk/>
            <pc:sldMk cId="2737564786" sldId="1544"/>
            <ac:spMk id="34" creationId="{1A144062-55D0-49E9-A9C4-074C36101BC0}"/>
          </ac:spMkLst>
        </pc:spChg>
        <pc:spChg chg="mod">
          <ac:chgData name="築家　恵美" userId="f8a515c7-036c-4132-9fc2-097c41d54ccb" providerId="ADAL" clId="{81FA8B9A-D47D-4B52-9BCA-1B9555F31D88}" dt="2023-07-31T05:36:59.036" v="534" actId="1076"/>
          <ac:spMkLst>
            <pc:docMk/>
            <pc:sldMk cId="2737564786" sldId="1544"/>
            <ac:spMk id="35" creationId="{11FE1617-F8C2-45BC-BEE9-EB606305D068}"/>
          </ac:spMkLst>
        </pc:spChg>
        <pc:spChg chg="mod">
          <ac:chgData name="築家　恵美" userId="f8a515c7-036c-4132-9fc2-097c41d54ccb" providerId="ADAL" clId="{81FA8B9A-D47D-4B52-9BCA-1B9555F31D88}" dt="2023-07-31T05:50:29.795" v="756" actId="1076"/>
          <ac:spMkLst>
            <pc:docMk/>
            <pc:sldMk cId="2737564786" sldId="1544"/>
            <ac:spMk id="36" creationId="{8122FBE5-94BB-44A3-A972-B178007D01ED}"/>
          </ac:spMkLst>
        </pc:spChg>
        <pc:spChg chg="add mod">
          <ac:chgData name="築家　恵美" userId="f8a515c7-036c-4132-9fc2-097c41d54ccb" providerId="ADAL" clId="{81FA8B9A-D47D-4B52-9BCA-1B9555F31D88}" dt="2023-07-31T05:19:21.771" v="365" actId="12789"/>
          <ac:spMkLst>
            <pc:docMk/>
            <pc:sldMk cId="2737564786" sldId="1544"/>
            <ac:spMk id="44" creationId="{07CF113D-02E5-A4D2-B872-690A3F4F8ED1}"/>
          </ac:spMkLst>
        </pc:spChg>
        <pc:spChg chg="add mod">
          <ac:chgData name="築家　恵美" userId="f8a515c7-036c-4132-9fc2-097c41d54ccb" providerId="ADAL" clId="{81FA8B9A-D47D-4B52-9BCA-1B9555F31D88}" dt="2023-07-31T05:19:03.814" v="364" actId="555"/>
          <ac:spMkLst>
            <pc:docMk/>
            <pc:sldMk cId="2737564786" sldId="1544"/>
            <ac:spMk id="45" creationId="{1959A53B-98ED-789B-4CFA-738FD8E76C56}"/>
          </ac:spMkLst>
        </pc:spChg>
        <pc:spChg chg="add mod">
          <ac:chgData name="築家　恵美" userId="f8a515c7-036c-4132-9fc2-097c41d54ccb" providerId="ADAL" clId="{81FA8B9A-D47D-4B52-9BCA-1B9555F31D88}" dt="2023-07-31T05:19:03.814" v="364" actId="555"/>
          <ac:spMkLst>
            <pc:docMk/>
            <pc:sldMk cId="2737564786" sldId="1544"/>
            <ac:spMk id="46" creationId="{41B8860F-D468-73A0-F8A4-979DE193F00E}"/>
          </ac:spMkLst>
        </pc:spChg>
        <pc:spChg chg="add mod">
          <ac:chgData name="築家　恵美" userId="f8a515c7-036c-4132-9fc2-097c41d54ccb" providerId="ADAL" clId="{81FA8B9A-D47D-4B52-9BCA-1B9555F31D88}" dt="2023-07-25T03:43:20.483" v="32" actId="14100"/>
          <ac:spMkLst>
            <pc:docMk/>
            <pc:sldMk cId="2737564786" sldId="1544"/>
            <ac:spMk id="46" creationId="{88CE27EA-E6EF-3F10-E835-6B4B7933AA42}"/>
          </ac:spMkLst>
        </pc:spChg>
        <pc:spChg chg="add mod">
          <ac:chgData name="築家　恵美" userId="f8a515c7-036c-4132-9fc2-097c41d54ccb" providerId="ADAL" clId="{81FA8B9A-D47D-4B52-9BCA-1B9555F31D88}" dt="2023-07-31T05:19:21.771" v="365" actId="12789"/>
          <ac:spMkLst>
            <pc:docMk/>
            <pc:sldMk cId="2737564786" sldId="1544"/>
            <ac:spMk id="47" creationId="{CB9F39B6-BC7E-3246-6CD3-4F2CC088B324}"/>
          </ac:spMkLst>
        </pc:spChg>
        <pc:spChg chg="add mod">
          <ac:chgData name="築家　恵美" userId="f8a515c7-036c-4132-9fc2-097c41d54ccb" providerId="ADAL" clId="{81FA8B9A-D47D-4B52-9BCA-1B9555F31D88}" dt="2023-07-31T05:19:21.771" v="365" actId="12789"/>
          <ac:spMkLst>
            <pc:docMk/>
            <pc:sldMk cId="2737564786" sldId="1544"/>
            <ac:spMk id="48" creationId="{FBA573A6-B2FA-1B34-B2C9-F164CE03098F}"/>
          </ac:spMkLst>
        </pc:spChg>
        <pc:spChg chg="add mod">
          <ac:chgData name="築家　恵美" userId="f8a515c7-036c-4132-9fc2-097c41d54ccb" providerId="ADAL" clId="{81FA8B9A-D47D-4B52-9BCA-1B9555F31D88}" dt="2023-07-31T05:19:03.814" v="364" actId="555"/>
          <ac:spMkLst>
            <pc:docMk/>
            <pc:sldMk cId="2737564786" sldId="1544"/>
            <ac:spMk id="49" creationId="{78C61551-33D7-E9E3-9300-229AD79CCEB5}"/>
          </ac:spMkLst>
        </pc:spChg>
        <pc:spChg chg="add mod">
          <ac:chgData name="築家　恵美" userId="f8a515c7-036c-4132-9fc2-097c41d54ccb" providerId="ADAL" clId="{81FA8B9A-D47D-4B52-9BCA-1B9555F31D88}" dt="2023-07-31T05:19:21.771" v="365" actId="12789"/>
          <ac:spMkLst>
            <pc:docMk/>
            <pc:sldMk cId="2737564786" sldId="1544"/>
            <ac:spMk id="50" creationId="{C17A09E4-B089-D79D-53B5-ED8E41D76A84}"/>
          </ac:spMkLst>
        </pc:spChg>
        <pc:spChg chg="add mod">
          <ac:chgData name="築家　恵美" userId="f8a515c7-036c-4132-9fc2-097c41d54ccb" providerId="ADAL" clId="{81FA8B9A-D47D-4B52-9BCA-1B9555F31D88}" dt="2023-07-31T05:19:03.814" v="364" actId="555"/>
          <ac:spMkLst>
            <pc:docMk/>
            <pc:sldMk cId="2737564786" sldId="1544"/>
            <ac:spMk id="51" creationId="{E7D94DA4-E0F5-B302-3B4F-FFA066132F7D}"/>
          </ac:spMkLst>
        </pc:spChg>
        <pc:spChg chg="add mod">
          <ac:chgData name="築家　恵美" userId="f8a515c7-036c-4132-9fc2-097c41d54ccb" providerId="ADAL" clId="{81FA8B9A-D47D-4B52-9BCA-1B9555F31D88}" dt="2023-07-31T05:20:25.128" v="380" actId="1076"/>
          <ac:spMkLst>
            <pc:docMk/>
            <pc:sldMk cId="2737564786" sldId="1544"/>
            <ac:spMk id="57" creationId="{C76E7901-70F8-EFC7-AF36-7904A3441C3C}"/>
          </ac:spMkLst>
        </pc:spChg>
        <pc:spChg chg="add mod">
          <ac:chgData name="築家　恵美" userId="f8a515c7-036c-4132-9fc2-097c41d54ccb" providerId="ADAL" clId="{81FA8B9A-D47D-4B52-9BCA-1B9555F31D88}" dt="2023-07-31T05:20:29.935" v="382" actId="1076"/>
          <ac:spMkLst>
            <pc:docMk/>
            <pc:sldMk cId="2737564786" sldId="1544"/>
            <ac:spMk id="58" creationId="{A7FAB935-2A3D-2CC2-9432-89AD4631C8E1}"/>
          </ac:spMkLst>
        </pc:spChg>
        <pc:spChg chg="add mod">
          <ac:chgData name="築家　恵美" userId="f8a515c7-036c-4132-9fc2-097c41d54ccb" providerId="ADAL" clId="{81FA8B9A-D47D-4B52-9BCA-1B9555F31D88}" dt="2023-07-31T05:20:34.262" v="384" actId="1076"/>
          <ac:spMkLst>
            <pc:docMk/>
            <pc:sldMk cId="2737564786" sldId="1544"/>
            <ac:spMk id="59" creationId="{ECCD8B1A-7942-D803-2B63-9710E1D1CB50}"/>
          </ac:spMkLst>
        </pc:spChg>
        <pc:spChg chg="add mod">
          <ac:chgData name="築家　恵美" userId="f8a515c7-036c-4132-9fc2-097c41d54ccb" providerId="ADAL" clId="{81FA8B9A-D47D-4B52-9BCA-1B9555F31D88}" dt="2023-07-31T05:20:43.535" v="387" actId="1076"/>
          <ac:spMkLst>
            <pc:docMk/>
            <pc:sldMk cId="2737564786" sldId="1544"/>
            <ac:spMk id="60" creationId="{517E1CD2-DB2C-0B69-28CA-3EB0AD068CA4}"/>
          </ac:spMkLst>
        </pc:spChg>
        <pc:spChg chg="add mod">
          <ac:chgData name="築家　恵美" userId="f8a515c7-036c-4132-9fc2-097c41d54ccb" providerId="ADAL" clId="{81FA8B9A-D47D-4B52-9BCA-1B9555F31D88}" dt="2023-07-31T05:34:40.645" v="452" actId="12788"/>
          <ac:spMkLst>
            <pc:docMk/>
            <pc:sldMk cId="2737564786" sldId="1544"/>
            <ac:spMk id="63" creationId="{37D0922D-BC0C-E315-2392-2B94D2FD7AE8}"/>
          </ac:spMkLst>
        </pc:spChg>
        <pc:spChg chg="add mod">
          <ac:chgData name="築家　恵美" userId="f8a515c7-036c-4132-9fc2-097c41d54ccb" providerId="ADAL" clId="{81FA8B9A-D47D-4B52-9BCA-1B9555F31D88}" dt="2023-07-31T05:36:14.568" v="526" actId="552"/>
          <ac:spMkLst>
            <pc:docMk/>
            <pc:sldMk cId="2737564786" sldId="1544"/>
            <ac:spMk id="64" creationId="{3EFE8346-E940-9C17-BED4-CE42C2F2D7A3}"/>
          </ac:spMkLst>
        </pc:spChg>
        <pc:spChg chg="add mod">
          <ac:chgData name="築家　恵美" userId="f8a515c7-036c-4132-9fc2-097c41d54ccb" providerId="ADAL" clId="{81FA8B9A-D47D-4B52-9BCA-1B9555F31D88}" dt="2023-07-31T05:36:14.568" v="526" actId="552"/>
          <ac:spMkLst>
            <pc:docMk/>
            <pc:sldMk cId="2737564786" sldId="1544"/>
            <ac:spMk id="65" creationId="{D3367924-EDC1-9258-1FFE-F6673A6A7601}"/>
          </ac:spMkLst>
        </pc:spChg>
        <pc:spChg chg="add mod">
          <ac:chgData name="築家　恵美" userId="f8a515c7-036c-4132-9fc2-097c41d54ccb" providerId="ADAL" clId="{81FA8B9A-D47D-4B52-9BCA-1B9555F31D88}" dt="2023-07-31T05:38:46.606" v="550" actId="1037"/>
          <ac:spMkLst>
            <pc:docMk/>
            <pc:sldMk cId="2737564786" sldId="1544"/>
            <ac:spMk id="66" creationId="{64BB42FB-6394-110B-D961-0BDC69A080EF}"/>
          </ac:spMkLst>
        </pc:spChg>
        <pc:spChg chg="add mod">
          <ac:chgData name="築家　恵美" userId="f8a515c7-036c-4132-9fc2-097c41d54ccb" providerId="ADAL" clId="{81FA8B9A-D47D-4B52-9BCA-1B9555F31D88}" dt="2023-07-31T05:39:08.489" v="554" actId="14100"/>
          <ac:spMkLst>
            <pc:docMk/>
            <pc:sldMk cId="2737564786" sldId="1544"/>
            <ac:spMk id="67" creationId="{0BCE1877-6EA5-4F7A-C11C-A9054EB29E71}"/>
          </ac:spMkLst>
        </pc:spChg>
        <pc:spChg chg="add mod">
          <ac:chgData name="築家　恵美" userId="f8a515c7-036c-4132-9fc2-097c41d54ccb" providerId="ADAL" clId="{81FA8B9A-D47D-4B52-9BCA-1B9555F31D88}" dt="2023-07-31T05:40:38.806" v="570" actId="1076"/>
          <ac:spMkLst>
            <pc:docMk/>
            <pc:sldMk cId="2737564786" sldId="1544"/>
            <ac:spMk id="68" creationId="{02DD7BDB-C9E4-1CA9-CC42-4A8D14ADDC1D}"/>
          </ac:spMkLst>
        </pc:spChg>
        <pc:spChg chg="add mod">
          <ac:chgData name="築家　恵美" userId="f8a515c7-036c-4132-9fc2-097c41d54ccb" providerId="ADAL" clId="{81FA8B9A-D47D-4B52-9BCA-1B9555F31D88}" dt="2023-07-31T05:40:29.600" v="569" actId="20577"/>
          <ac:spMkLst>
            <pc:docMk/>
            <pc:sldMk cId="2737564786" sldId="1544"/>
            <ac:spMk id="69" creationId="{1F9D4B04-F2F3-DEA8-59BD-2897C8E27FA6}"/>
          </ac:spMkLst>
        </pc:spChg>
        <pc:spChg chg="add mod">
          <ac:chgData name="築家　恵美" userId="f8a515c7-036c-4132-9fc2-097c41d54ccb" providerId="ADAL" clId="{81FA8B9A-D47D-4B52-9BCA-1B9555F31D88}" dt="2023-07-31T05:48:13.185" v="719" actId="1038"/>
          <ac:spMkLst>
            <pc:docMk/>
            <pc:sldMk cId="2737564786" sldId="1544"/>
            <ac:spMk id="79" creationId="{A8F016C6-6F63-0D14-5A29-6DB01153893B}"/>
          </ac:spMkLst>
        </pc:spChg>
        <pc:picChg chg="mod ord">
          <ac:chgData name="築家　恵美" userId="f8a515c7-036c-4132-9fc2-097c41d54ccb" providerId="ADAL" clId="{81FA8B9A-D47D-4B52-9BCA-1B9555F31D88}" dt="2023-07-31T05:57:48.010" v="780" actId="554"/>
          <ac:picMkLst>
            <pc:docMk/>
            <pc:sldMk cId="2737564786" sldId="1544"/>
            <ac:picMk id="5" creationId="{59AB4315-01AB-437A-B29D-9901264C81FB}"/>
          </ac:picMkLst>
        </pc:picChg>
        <pc:picChg chg="mod">
          <ac:chgData name="築家　恵美" userId="f8a515c7-036c-4132-9fc2-097c41d54ccb" providerId="ADAL" clId="{81FA8B9A-D47D-4B52-9BCA-1B9555F31D88}" dt="2023-07-31T05:37:31.579" v="542" actId="554"/>
          <ac:picMkLst>
            <pc:docMk/>
            <pc:sldMk cId="2737564786" sldId="1544"/>
            <ac:picMk id="6" creationId="{E84D135F-2565-4B9B-8977-75E4F3088D15}"/>
          </ac:picMkLst>
        </pc:picChg>
        <pc:picChg chg="mod">
          <ac:chgData name="築家　恵美" userId="f8a515c7-036c-4132-9fc2-097c41d54ccb" providerId="ADAL" clId="{81FA8B9A-D47D-4B52-9BCA-1B9555F31D88}" dt="2023-07-31T05:42:08.093" v="582" actId="1076"/>
          <ac:picMkLst>
            <pc:docMk/>
            <pc:sldMk cId="2737564786" sldId="1544"/>
            <ac:picMk id="7" creationId="{A58F503C-89E5-418C-BB21-6F282F5ECB9E}"/>
          </ac:picMkLst>
        </pc:picChg>
        <pc:picChg chg="mod ord">
          <ac:chgData name="築家　恵美" userId="f8a515c7-036c-4132-9fc2-097c41d54ccb" providerId="ADAL" clId="{81FA8B9A-D47D-4B52-9BCA-1B9555F31D88}" dt="2023-07-31T05:57:59.881" v="781" actId="554"/>
          <ac:picMkLst>
            <pc:docMk/>
            <pc:sldMk cId="2737564786" sldId="1544"/>
            <ac:picMk id="8" creationId="{5E7EB850-43AC-9A4E-D94B-99443A94BD99}"/>
          </ac:picMkLst>
        </pc:picChg>
        <pc:picChg chg="mod ord">
          <ac:chgData name="築家　恵美" userId="f8a515c7-036c-4132-9fc2-097c41d54ccb" providerId="ADAL" clId="{81FA8B9A-D47D-4B52-9BCA-1B9555F31D88}" dt="2023-07-31T05:58:06.608" v="782" actId="554"/>
          <ac:picMkLst>
            <pc:docMk/>
            <pc:sldMk cId="2737564786" sldId="1544"/>
            <ac:picMk id="9" creationId="{DA6387BA-2D94-62AD-AD7E-4F53C08BDF96}"/>
          </ac:picMkLst>
        </pc:picChg>
        <pc:picChg chg="add del mod">
          <ac:chgData name="築家　恵美" userId="f8a515c7-036c-4132-9fc2-097c41d54ccb" providerId="ADAL" clId="{81FA8B9A-D47D-4B52-9BCA-1B9555F31D88}" dt="2023-07-31T05:12:38.326" v="58" actId="478"/>
          <ac:picMkLst>
            <pc:docMk/>
            <pc:sldMk cId="2737564786" sldId="1544"/>
            <ac:picMk id="11" creationId="{3D68DDD9-B4BE-6E2E-850A-FDCCE9DCCD1C}"/>
          </ac:picMkLst>
        </pc:picChg>
        <pc:picChg chg="mod">
          <ac:chgData name="築家　恵美" userId="f8a515c7-036c-4132-9fc2-097c41d54ccb" providerId="ADAL" clId="{81FA8B9A-D47D-4B52-9BCA-1B9555F31D88}" dt="2023-07-31T05:42:01.603" v="581" actId="554"/>
          <ac:picMkLst>
            <pc:docMk/>
            <pc:sldMk cId="2737564786" sldId="1544"/>
            <ac:picMk id="13" creationId="{70026DAB-78A9-4C96-B357-439813CDC28E}"/>
          </ac:picMkLst>
        </pc:picChg>
        <pc:picChg chg="add del mod">
          <ac:chgData name="築家　恵美" userId="f8a515c7-036c-4132-9fc2-097c41d54ccb" providerId="ADAL" clId="{81FA8B9A-D47D-4B52-9BCA-1B9555F31D88}" dt="2023-07-31T05:12:42.473" v="60" actId="478"/>
          <ac:picMkLst>
            <pc:docMk/>
            <pc:sldMk cId="2737564786" sldId="1544"/>
            <ac:picMk id="18" creationId="{598F267F-4378-1F3C-B85F-456E0D64465F}"/>
          </ac:picMkLst>
        </pc:picChg>
        <pc:picChg chg="add mod">
          <ac:chgData name="築家　恵美" userId="f8a515c7-036c-4132-9fc2-097c41d54ccb" providerId="ADAL" clId="{81FA8B9A-D47D-4B52-9BCA-1B9555F31D88}" dt="2023-07-31T05:24:32.619" v="415" actId="553"/>
          <ac:picMkLst>
            <pc:docMk/>
            <pc:sldMk cId="2737564786" sldId="1544"/>
            <ac:picMk id="21" creationId="{C8B2F9F3-9C44-D7B4-3981-940EE7DEBB79}"/>
          </ac:picMkLst>
        </pc:picChg>
        <pc:picChg chg="add del">
          <ac:chgData name="築家　恵美" userId="f8a515c7-036c-4132-9fc2-097c41d54ccb" providerId="ADAL" clId="{81FA8B9A-D47D-4B52-9BCA-1B9555F31D88}" dt="2023-07-31T05:12:40.166" v="59" actId="478"/>
          <ac:picMkLst>
            <pc:docMk/>
            <pc:sldMk cId="2737564786" sldId="1544"/>
            <ac:picMk id="34" creationId="{387B0A80-B1A1-D57B-3F4F-7BB4C3089290}"/>
          </ac:picMkLst>
        </pc:picChg>
        <pc:picChg chg="add mod">
          <ac:chgData name="築家　恵美" userId="f8a515c7-036c-4132-9fc2-097c41d54ccb" providerId="ADAL" clId="{81FA8B9A-D47D-4B52-9BCA-1B9555F31D88}" dt="2023-07-31T05:16:47.082" v="139" actId="408"/>
          <ac:picMkLst>
            <pc:docMk/>
            <pc:sldMk cId="2737564786" sldId="1544"/>
            <ac:picMk id="38" creationId="{2CBC06DB-1C57-6F28-E30B-A5459781955D}"/>
          </ac:picMkLst>
        </pc:picChg>
        <pc:picChg chg="add mod">
          <ac:chgData name="築家　恵美" userId="f8a515c7-036c-4132-9fc2-097c41d54ccb" providerId="ADAL" clId="{81FA8B9A-D47D-4B52-9BCA-1B9555F31D88}" dt="2023-07-31T05:16:47.082" v="139" actId="408"/>
          <ac:picMkLst>
            <pc:docMk/>
            <pc:sldMk cId="2737564786" sldId="1544"/>
            <ac:picMk id="41" creationId="{6DD218D0-C193-D61D-17E1-B2206E1637F9}"/>
          </ac:picMkLst>
        </pc:picChg>
        <pc:picChg chg="add mod">
          <ac:chgData name="築家　恵美" userId="f8a515c7-036c-4132-9fc2-097c41d54ccb" providerId="ADAL" clId="{81FA8B9A-D47D-4B52-9BCA-1B9555F31D88}" dt="2023-07-31T05:16:42.771" v="138" actId="554"/>
          <ac:picMkLst>
            <pc:docMk/>
            <pc:sldMk cId="2737564786" sldId="1544"/>
            <ac:picMk id="43" creationId="{B2447314-ECF9-CD9E-1165-4B152C911397}"/>
          </ac:picMkLst>
        </pc:picChg>
        <pc:cxnChg chg="add mod">
          <ac:chgData name="築家　恵美" userId="f8a515c7-036c-4132-9fc2-097c41d54ccb" providerId="ADAL" clId="{81FA8B9A-D47D-4B52-9BCA-1B9555F31D88}" dt="2023-07-25T03:39:46.142" v="7" actId="208"/>
          <ac:cxnSpMkLst>
            <pc:docMk/>
            <pc:sldMk cId="2737564786" sldId="1544"/>
            <ac:cxnSpMk id="9" creationId="{D089514A-9AA9-D3C7-47D1-7FF645E76CC4}"/>
          </ac:cxnSpMkLst>
        </pc:cxnChg>
        <pc:cxnChg chg="add mod">
          <ac:chgData name="築家　恵美" userId="f8a515c7-036c-4132-9fc2-097c41d54ccb" providerId="ADAL" clId="{81FA8B9A-D47D-4B52-9BCA-1B9555F31D88}" dt="2023-07-31T05:53:54.377" v="759" actId="14100"/>
          <ac:cxnSpMkLst>
            <pc:docMk/>
            <pc:sldMk cId="2737564786" sldId="1544"/>
            <ac:cxnSpMk id="10" creationId="{BF9E2217-644C-082C-AF20-3DD4E994FFCD}"/>
          </ac:cxnSpMkLst>
        </pc:cxnChg>
        <pc:cxnChg chg="add mod">
          <ac:chgData name="築家　恵美" userId="f8a515c7-036c-4132-9fc2-097c41d54ccb" providerId="ADAL" clId="{81FA8B9A-D47D-4B52-9BCA-1B9555F31D88}" dt="2023-07-25T03:40:53.970" v="18" actId="14100"/>
          <ac:cxnSpMkLst>
            <pc:docMk/>
            <pc:sldMk cId="2737564786" sldId="1544"/>
            <ac:cxnSpMk id="11" creationId="{2496ED40-A551-7D29-80AF-8D3B3CECDAC4}"/>
          </ac:cxnSpMkLst>
        </pc:cxnChg>
        <pc:cxnChg chg="mod">
          <ac:chgData name="築家　恵美" userId="f8a515c7-036c-4132-9fc2-097c41d54ccb" providerId="ADAL" clId="{81FA8B9A-D47D-4B52-9BCA-1B9555F31D88}" dt="2023-08-04T23:28:36.976" v="785" actId="1582"/>
          <ac:cxnSpMkLst>
            <pc:docMk/>
            <pc:sldMk cId="2737564786" sldId="1544"/>
            <ac:cxnSpMk id="12" creationId="{266CDAD2-3712-4213-B697-20E4771F911D}"/>
          </ac:cxnSpMkLst>
        </pc:cxnChg>
        <pc:cxnChg chg="mod">
          <ac:chgData name="築家　恵美" userId="f8a515c7-036c-4132-9fc2-097c41d54ccb" providerId="ADAL" clId="{81FA8B9A-D47D-4B52-9BCA-1B9555F31D88}" dt="2023-08-04T23:28:11.911" v="784" actId="14100"/>
          <ac:cxnSpMkLst>
            <pc:docMk/>
            <pc:sldMk cId="2737564786" sldId="1544"/>
            <ac:cxnSpMk id="14" creationId="{03365C0D-930B-401B-BA91-A1BC730C08A3}"/>
          </ac:cxnSpMkLst>
        </pc:cxnChg>
        <pc:cxnChg chg="del mod">
          <ac:chgData name="築家　恵美" userId="f8a515c7-036c-4132-9fc2-097c41d54ccb" providerId="ADAL" clId="{81FA8B9A-D47D-4B52-9BCA-1B9555F31D88}" dt="2023-07-31T05:49:30.035" v="744" actId="478"/>
          <ac:cxnSpMkLst>
            <pc:docMk/>
            <pc:sldMk cId="2737564786" sldId="1544"/>
            <ac:cxnSpMk id="15" creationId="{94472C14-F3A9-40A8-B9C9-EA7026410631}"/>
          </ac:cxnSpMkLst>
        </pc:cxnChg>
        <pc:cxnChg chg="add mod">
          <ac:chgData name="築家　恵美" userId="f8a515c7-036c-4132-9fc2-097c41d54ccb" providerId="ADAL" clId="{81FA8B9A-D47D-4B52-9BCA-1B9555F31D88}" dt="2023-07-31T05:54:43.576" v="768" actId="14100"/>
          <ac:cxnSpMkLst>
            <pc:docMk/>
            <pc:sldMk cId="2737564786" sldId="1544"/>
            <ac:cxnSpMk id="15" creationId="{BE05A7D4-D5ED-848E-B576-0BF70AB8E38D}"/>
          </ac:cxnSpMkLst>
        </pc:cxnChg>
        <pc:cxnChg chg="mod">
          <ac:chgData name="築家　恵美" userId="f8a515c7-036c-4132-9fc2-097c41d54ccb" providerId="ADAL" clId="{81FA8B9A-D47D-4B52-9BCA-1B9555F31D88}" dt="2023-08-04T23:32:05.980" v="797" actId="1037"/>
          <ac:cxnSpMkLst>
            <pc:docMk/>
            <pc:sldMk cId="2737564786" sldId="1544"/>
            <ac:cxnSpMk id="16" creationId="{17B81A3E-20A0-433E-942E-EDA82C0F5CC7}"/>
          </ac:cxnSpMkLst>
        </pc:cxnChg>
        <pc:cxnChg chg="del">
          <ac:chgData name="築家　恵美" userId="f8a515c7-036c-4132-9fc2-097c41d54ccb" providerId="ADAL" clId="{81FA8B9A-D47D-4B52-9BCA-1B9555F31D88}" dt="2023-07-25T03:39:58.051" v="8" actId="478"/>
          <ac:cxnSpMkLst>
            <pc:docMk/>
            <pc:sldMk cId="2737564786" sldId="1544"/>
            <ac:cxnSpMk id="17" creationId="{30B8C6A5-90C9-4F90-B9D6-9A556323C067}"/>
          </ac:cxnSpMkLst>
        </pc:cxnChg>
        <pc:cxnChg chg="del">
          <ac:chgData name="築家　恵美" userId="f8a515c7-036c-4132-9fc2-097c41d54ccb" providerId="ADAL" clId="{81FA8B9A-D47D-4B52-9BCA-1B9555F31D88}" dt="2023-07-25T03:40:01.883" v="9" actId="478"/>
          <ac:cxnSpMkLst>
            <pc:docMk/>
            <pc:sldMk cId="2737564786" sldId="1544"/>
            <ac:cxnSpMk id="18" creationId="{9A2E005D-B84B-4019-A404-E2D47BF0DBEF}"/>
          </ac:cxnSpMkLst>
        </pc:cxnChg>
        <pc:cxnChg chg="add mod">
          <ac:chgData name="築家　恵美" userId="f8a515c7-036c-4132-9fc2-097c41d54ccb" providerId="ADAL" clId="{81FA8B9A-D47D-4B52-9BCA-1B9555F31D88}" dt="2023-07-31T05:54:46.377" v="773" actId="1037"/>
          <ac:cxnSpMkLst>
            <pc:docMk/>
            <pc:sldMk cId="2737564786" sldId="1544"/>
            <ac:cxnSpMk id="20" creationId="{17D45DE5-A57F-68D8-A6BF-91BE67FF689D}"/>
          </ac:cxnSpMkLst>
        </pc:cxnChg>
        <pc:cxnChg chg="mod">
          <ac:chgData name="築家　恵美" userId="f8a515c7-036c-4132-9fc2-097c41d54ccb" providerId="ADAL" clId="{81FA8B9A-D47D-4B52-9BCA-1B9555F31D88}" dt="2023-07-31T05:45:08.756" v="654" actId="1037"/>
          <ac:cxnSpMkLst>
            <pc:docMk/>
            <pc:sldMk cId="2737564786" sldId="1544"/>
            <ac:cxnSpMk id="22" creationId="{9A255FB2-CB5B-4219-B93A-78AF46D1EE6C}"/>
          </ac:cxnSpMkLst>
        </pc:cxnChg>
        <pc:cxnChg chg="add mod">
          <ac:chgData name="築家　恵美" userId="f8a515c7-036c-4132-9fc2-097c41d54ccb" providerId="ADAL" clId="{81FA8B9A-D47D-4B52-9BCA-1B9555F31D88}" dt="2023-07-25T03:41:05.412" v="22" actId="1076"/>
          <ac:cxnSpMkLst>
            <pc:docMk/>
            <pc:sldMk cId="2737564786" sldId="1544"/>
            <ac:cxnSpMk id="37" creationId="{0C33330D-D4BA-E452-750E-26A6649F9D41}"/>
          </ac:cxnSpMkLst>
        </pc:cxnChg>
        <pc:cxnChg chg="mod">
          <ac:chgData name="築家　恵美" userId="f8a515c7-036c-4132-9fc2-097c41d54ccb" providerId="ADAL" clId="{81FA8B9A-D47D-4B52-9BCA-1B9555F31D88}" dt="2023-07-31T05:37:07.859" v="536" actId="1037"/>
          <ac:cxnSpMkLst>
            <pc:docMk/>
            <pc:sldMk cId="2737564786" sldId="1544"/>
            <ac:cxnSpMk id="40" creationId="{63B22733-76F1-D0D7-82D0-6898BD35937A}"/>
          </ac:cxnSpMkLst>
        </pc:cxnChg>
        <pc:cxnChg chg="add del mod">
          <ac:chgData name="築家　恵美" userId="f8a515c7-036c-4132-9fc2-097c41d54ccb" providerId="ADAL" clId="{81FA8B9A-D47D-4B52-9BCA-1B9555F31D88}" dt="2023-08-04T23:31:46.878" v="796" actId="478"/>
          <ac:cxnSpMkLst>
            <pc:docMk/>
            <pc:sldMk cId="2737564786" sldId="1544"/>
            <ac:cxnSpMk id="52" creationId="{3357A8D7-0E9C-6F5F-78E4-C16B422F787D}"/>
          </ac:cxnSpMkLst>
        </pc:cxnChg>
        <pc:cxnChg chg="add mod">
          <ac:chgData name="築家　恵美" userId="f8a515c7-036c-4132-9fc2-097c41d54ccb" providerId="ADAL" clId="{81FA8B9A-D47D-4B52-9BCA-1B9555F31D88}" dt="2023-07-31T05:20:08.493" v="375" actId="555"/>
          <ac:cxnSpMkLst>
            <pc:docMk/>
            <pc:sldMk cId="2737564786" sldId="1544"/>
            <ac:cxnSpMk id="53" creationId="{302198D8-06B2-552F-8505-DE40F8CAD8BC}"/>
          </ac:cxnSpMkLst>
        </pc:cxnChg>
        <pc:cxnChg chg="add mod">
          <ac:chgData name="築家　恵美" userId="f8a515c7-036c-4132-9fc2-097c41d54ccb" providerId="ADAL" clId="{81FA8B9A-D47D-4B52-9BCA-1B9555F31D88}" dt="2023-07-31T05:20:08.493" v="375" actId="555"/>
          <ac:cxnSpMkLst>
            <pc:docMk/>
            <pc:sldMk cId="2737564786" sldId="1544"/>
            <ac:cxnSpMk id="54" creationId="{071119E4-C179-87BA-AE91-D07B2CEA10ED}"/>
          </ac:cxnSpMkLst>
        </pc:cxnChg>
        <pc:cxnChg chg="add mod">
          <ac:chgData name="築家　恵美" userId="f8a515c7-036c-4132-9fc2-097c41d54ccb" providerId="ADAL" clId="{81FA8B9A-D47D-4B52-9BCA-1B9555F31D88}" dt="2023-07-31T05:20:08.493" v="375" actId="555"/>
          <ac:cxnSpMkLst>
            <pc:docMk/>
            <pc:sldMk cId="2737564786" sldId="1544"/>
            <ac:cxnSpMk id="55" creationId="{93B07FC2-22DC-524E-AC47-6765FF577FCF}"/>
          </ac:cxnSpMkLst>
        </pc:cxnChg>
        <pc:cxnChg chg="add del mod">
          <ac:chgData name="築家　恵美" userId="f8a515c7-036c-4132-9fc2-097c41d54ccb" providerId="ADAL" clId="{81FA8B9A-D47D-4B52-9BCA-1B9555F31D88}" dt="2023-07-31T05:19:57.962" v="374" actId="478"/>
          <ac:cxnSpMkLst>
            <pc:docMk/>
            <pc:sldMk cId="2737564786" sldId="1544"/>
            <ac:cxnSpMk id="56" creationId="{59346AA7-6DD2-39A9-2939-2A9EEBF6BD31}"/>
          </ac:cxnSpMkLst>
        </pc:cxnChg>
        <pc:cxnChg chg="add mod">
          <ac:chgData name="築家　恵美" userId="f8a515c7-036c-4132-9fc2-097c41d54ccb" providerId="ADAL" clId="{81FA8B9A-D47D-4B52-9BCA-1B9555F31D88}" dt="2023-07-31T05:23:59.493" v="411" actId="1076"/>
          <ac:cxnSpMkLst>
            <pc:docMk/>
            <pc:sldMk cId="2737564786" sldId="1544"/>
            <ac:cxnSpMk id="62" creationId="{E0D806CB-1EBD-EFAC-F1C1-62819A9090A2}"/>
          </ac:cxnSpMkLst>
        </pc:cxnChg>
        <pc:cxnChg chg="add mod">
          <ac:chgData name="築家　恵美" userId="f8a515c7-036c-4132-9fc2-097c41d54ccb" providerId="ADAL" clId="{81FA8B9A-D47D-4B52-9BCA-1B9555F31D88}" dt="2023-08-04T23:32:19.831" v="801" actId="1035"/>
          <ac:cxnSpMkLst>
            <pc:docMk/>
            <pc:sldMk cId="2737564786" sldId="1544"/>
            <ac:cxnSpMk id="72" creationId="{CC95587C-E585-62E9-8747-22B39509BEB6}"/>
          </ac:cxnSpMkLst>
        </pc:cxnChg>
      </pc:sldChg>
    </pc:docChg>
  </pc:docChgLst>
  <pc:docChgLst>
    <pc:chgData name="佐伯　吉弘" userId="S::iop890@hiroshima-u.ac.jp::c48215f7-a175-419d-95e9-d9045df60879" providerId="AD" clId="Web-{D28BBBFA-84E0-AA73-F329-528E04C3DB9D}"/>
    <pc:docChg chg="modSld">
      <pc:chgData name="佐伯　吉弘" userId="S::iop890@hiroshima-u.ac.jp::c48215f7-a175-419d-95e9-d9045df60879" providerId="AD" clId="Web-{D28BBBFA-84E0-AA73-F329-528E04C3DB9D}" dt="2023-08-05T06:00:39.474" v="23" actId="14100"/>
      <pc:docMkLst>
        <pc:docMk/>
      </pc:docMkLst>
      <pc:sldChg chg="modSp">
        <pc:chgData name="佐伯　吉弘" userId="S::iop890@hiroshima-u.ac.jp::c48215f7-a175-419d-95e9-d9045df60879" providerId="AD" clId="Web-{D28BBBFA-84E0-AA73-F329-528E04C3DB9D}" dt="2023-08-05T06:00:39.474" v="23" actId="14100"/>
        <pc:sldMkLst>
          <pc:docMk/>
          <pc:sldMk cId="2737564786" sldId="1544"/>
        </pc:sldMkLst>
        <pc:spChg chg="mod">
          <ac:chgData name="佐伯　吉弘" userId="S::iop890@hiroshima-u.ac.jp::c48215f7-a175-419d-95e9-d9045df60879" providerId="AD" clId="Web-{D28BBBFA-84E0-AA73-F329-528E04C3DB9D}" dt="2023-08-05T05:45:41.408" v="3" actId="20577"/>
          <ac:spMkLst>
            <pc:docMk/>
            <pc:sldMk cId="2737564786" sldId="1544"/>
            <ac:spMk id="3" creationId="{35A9C8DC-D6FE-4AC6-81EF-BD99AD8BAD28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801" v="16" actId="20577"/>
          <ac:spMkLst>
            <pc:docMk/>
            <pc:sldMk cId="2737564786" sldId="1544"/>
            <ac:spMk id="11" creationId="{DA1F331C-4FAD-E3DD-B164-4F72297F9B15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833" v="17" actId="20577"/>
          <ac:spMkLst>
            <pc:docMk/>
            <pc:sldMk cId="2737564786" sldId="1544"/>
            <ac:spMk id="17" creationId="{F6F6790B-F0E2-FB69-EE6F-D9316F095EA8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848" v="18" actId="20577"/>
          <ac:spMkLst>
            <pc:docMk/>
            <pc:sldMk cId="2737564786" sldId="1544"/>
            <ac:spMk id="18" creationId="{B780783F-F40C-B950-5914-05E9548F742D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6:00:39.474" v="23" actId="14100"/>
          <ac:spMkLst>
            <pc:docMk/>
            <pc:sldMk cId="2737564786" sldId="1544"/>
            <ac:spMk id="19" creationId="{FC85D760-A1B7-4820-A2BA-58EAEE86F70E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739" v="13" actId="20577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45:32.267" v="1" actId="20577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45:51.830" v="11" actId="14100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45:45.830" v="7" actId="14100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46:00.377" v="12" actId="20577"/>
          <ac:spMkLst>
            <pc:docMk/>
            <pc:sldMk cId="2737564786" sldId="1544"/>
            <ac:spMk id="36" creationId="{8122FBE5-94BB-44A3-A972-B178007D01ED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770" v="14" actId="20577"/>
          <ac:spMkLst>
            <pc:docMk/>
            <pc:sldMk cId="2737564786" sldId="1544"/>
            <ac:spMk id="64" creationId="{3EFE8346-E940-9C17-BED4-CE42C2F2D7A3}"/>
          </ac:spMkLst>
        </pc:spChg>
        <pc:spChg chg="mod">
          <ac:chgData name="佐伯　吉弘" userId="S::iop890@hiroshima-u.ac.jp::c48215f7-a175-419d-95e9-d9045df60879" providerId="AD" clId="Web-{D28BBBFA-84E0-AA73-F329-528E04C3DB9D}" dt="2023-08-05T05:59:50.786" v="15" actId="20577"/>
          <ac:spMkLst>
            <pc:docMk/>
            <pc:sldMk cId="2737564786" sldId="1544"/>
            <ac:spMk id="67" creationId="{0BCE1877-6EA5-4F7A-C11C-A9054EB29E7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226083-64BA-4969-B66C-4DBCD541549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A97C7-1FFA-4487-ADDC-613D98C005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253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Exemplary FACS plots of T cells, NKT cells, NK cells, CD56bright NK cells and CD56dim NK cells of obese subject</a:t>
            </a:r>
          </a:p>
          <a:p>
            <a:r>
              <a:rPr kumimoji="1" lang="en-US" altLang="ja-JP" dirty="0"/>
              <a:t>Exemplary FACS plots of the CD69 expression on T cells, CD56bright NK cells and CD56dim NK cell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BA97C7-1FFA-4487-ADDC-613D98C005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0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183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326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52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7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0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06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602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42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37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64BE7-4756-4F8B-95AF-AA1714C89953}" type="datetimeFigureOut">
              <a:rPr kumimoji="1" lang="ja-JP" altLang="en-US" smtClean="0"/>
              <a:t>2023/8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019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59AB4315-01AB-437A-B29D-9901264C81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973" y="1902972"/>
            <a:ext cx="1462857" cy="144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E7EB850-43AC-9A4E-D94B-99443A94BD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973" y="3578415"/>
            <a:ext cx="1462857" cy="144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A6387BA-2D94-62AD-AD7E-4F53C08BDF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933" y="5253858"/>
            <a:ext cx="1462857" cy="144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0026DAB-78A9-4C96-B357-439813CDC2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1383" y="5253858"/>
            <a:ext cx="1462857" cy="1440000"/>
          </a:xfrm>
          <a:prstGeom prst="rect">
            <a:avLst/>
          </a:prstGeom>
        </p:spPr>
      </p:pic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9A255FB2-CB5B-4219-B93A-78AF46D1EE6C}"/>
              </a:ext>
            </a:extLst>
          </p:cNvPr>
          <p:cNvCxnSpPr>
            <a:cxnSpLocks/>
          </p:cNvCxnSpPr>
          <p:nvPr/>
        </p:nvCxnSpPr>
        <p:spPr>
          <a:xfrm>
            <a:off x="2733618" y="5828329"/>
            <a:ext cx="116903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A58F503C-89E5-418C-BB21-6F282F5ECB9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1928" y="5253858"/>
            <a:ext cx="1462857" cy="144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E84D135F-2565-4B9B-8977-75E4F3088D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45928" y="1902972"/>
            <a:ext cx="1462857" cy="1440000"/>
          </a:xfrm>
          <a:prstGeom prst="rect">
            <a:avLst/>
          </a:prstGeom>
        </p:spPr>
      </p:pic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66CDAD2-3712-4213-B697-20E4771F911D}"/>
              </a:ext>
            </a:extLst>
          </p:cNvPr>
          <p:cNvCxnSpPr>
            <a:cxnSpLocks/>
          </p:cNvCxnSpPr>
          <p:nvPr/>
        </p:nvCxnSpPr>
        <p:spPr>
          <a:xfrm>
            <a:off x="2733618" y="2806700"/>
            <a:ext cx="1169034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3365C0D-930B-401B-BA91-A1BC730C08A3}"/>
              </a:ext>
            </a:extLst>
          </p:cNvPr>
          <p:cNvCxnSpPr>
            <a:cxnSpLocks/>
          </p:cNvCxnSpPr>
          <p:nvPr/>
        </p:nvCxnSpPr>
        <p:spPr>
          <a:xfrm>
            <a:off x="3054565" y="1964267"/>
            <a:ext cx="0" cy="11618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17B81A3E-20A0-433E-942E-EDA82C0F5CC7}"/>
              </a:ext>
            </a:extLst>
          </p:cNvPr>
          <p:cNvCxnSpPr>
            <a:cxnSpLocks/>
          </p:cNvCxnSpPr>
          <p:nvPr/>
        </p:nvCxnSpPr>
        <p:spPr>
          <a:xfrm>
            <a:off x="4876704" y="5313043"/>
            <a:ext cx="0" cy="11639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C85D760-A1B7-4820-A2BA-58EAEE86F70E}"/>
              </a:ext>
            </a:extLst>
          </p:cNvPr>
          <p:cNvSpPr txBox="1"/>
          <p:nvPr/>
        </p:nvSpPr>
        <p:spPr>
          <a:xfrm>
            <a:off x="1933" y="-437"/>
            <a:ext cx="2041794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altLang="ja-JP" sz="1400" dirty="0">
                <a:effectLst/>
                <a:latin typeface="Arial"/>
                <a:ea typeface="游明朝"/>
                <a:cs typeface="Arial"/>
              </a:rPr>
              <a:t>Supplementary Fig. S1</a:t>
            </a:r>
            <a:endParaRPr lang="ja-JP" altLang="en-US" sz="1400">
              <a:latin typeface="Arial"/>
              <a:ea typeface="游明朝"/>
              <a:cs typeface="Arial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AB447A1-2784-4E6C-B313-4ABA3B863C89}"/>
              </a:ext>
            </a:extLst>
          </p:cNvPr>
          <p:cNvSpPr txBox="1"/>
          <p:nvPr/>
        </p:nvSpPr>
        <p:spPr>
          <a:xfrm rot="16200000">
            <a:off x="1820347" y="5750854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EAADF5A-E106-4677-888D-D7DA03805A5C}"/>
              </a:ext>
            </a:extLst>
          </p:cNvPr>
          <p:cNvSpPr txBox="1"/>
          <p:nvPr/>
        </p:nvSpPr>
        <p:spPr>
          <a:xfrm>
            <a:off x="946005" y="4905857"/>
            <a:ext cx="115086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2C73E29-822F-4869-99BB-9FE151171E63}"/>
              </a:ext>
            </a:extLst>
          </p:cNvPr>
          <p:cNvSpPr txBox="1"/>
          <p:nvPr/>
        </p:nvSpPr>
        <p:spPr>
          <a:xfrm>
            <a:off x="4679901" y="6584030"/>
            <a:ext cx="9773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9629508-9385-4E23-A8A2-E8A3D7329ABE}"/>
              </a:ext>
            </a:extLst>
          </p:cNvPr>
          <p:cNvSpPr txBox="1"/>
          <p:nvPr/>
        </p:nvSpPr>
        <p:spPr>
          <a:xfrm>
            <a:off x="2735206" y="3247684"/>
            <a:ext cx="9773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66A6F51-AA85-4E79-96A3-73983FF29AFC}"/>
              </a:ext>
            </a:extLst>
          </p:cNvPr>
          <p:cNvSpPr txBox="1"/>
          <p:nvPr/>
        </p:nvSpPr>
        <p:spPr>
          <a:xfrm>
            <a:off x="946005" y="6584030"/>
            <a:ext cx="115086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D2909E3-10F9-4298-8E4F-6FC8243417E6}"/>
              </a:ext>
            </a:extLst>
          </p:cNvPr>
          <p:cNvSpPr txBox="1"/>
          <p:nvPr/>
        </p:nvSpPr>
        <p:spPr>
          <a:xfrm rot="16200000">
            <a:off x="47087" y="2405599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CD56</a:t>
            </a:r>
            <a:endParaRPr lang="ja-JP" altLang="en-US" sz="1200">
              <a:latin typeface="Arial"/>
              <a:ea typeface="游ゴシック"/>
              <a:cs typeface="Arial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87F0079-DEDD-421B-8671-72B7415D8475}"/>
              </a:ext>
            </a:extLst>
          </p:cNvPr>
          <p:cNvSpPr txBox="1"/>
          <p:nvPr/>
        </p:nvSpPr>
        <p:spPr>
          <a:xfrm rot="16200000">
            <a:off x="3676547" y="5761406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4B3255-9DF0-47E5-AC29-22EAED094B5A}"/>
              </a:ext>
            </a:extLst>
          </p:cNvPr>
          <p:cNvSpPr txBox="1"/>
          <p:nvPr/>
        </p:nvSpPr>
        <p:spPr>
          <a:xfrm rot="16200000">
            <a:off x="1828168" y="240560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5A9C8DC-D6FE-4AC6-81EF-BD99AD8BAD28}"/>
              </a:ext>
            </a:extLst>
          </p:cNvPr>
          <p:cNvSpPr txBox="1"/>
          <p:nvPr/>
        </p:nvSpPr>
        <p:spPr>
          <a:xfrm>
            <a:off x="2653005" y="6076614"/>
            <a:ext cx="1286474" cy="2616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56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dim 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NK cells</a:t>
            </a:r>
            <a:endParaRPr kumimoji="1" lang="ja-JP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C37FE30-A9F9-4C46-9702-30DDE750778F}"/>
              </a:ext>
            </a:extLst>
          </p:cNvPr>
          <p:cNvSpPr txBox="1"/>
          <p:nvPr/>
        </p:nvSpPr>
        <p:spPr>
          <a:xfrm>
            <a:off x="2674898" y="5318435"/>
            <a:ext cx="1357635" cy="2616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56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bright 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NK cells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2D649BD-83BD-4C16-9649-E6805DE6755C}"/>
              </a:ext>
            </a:extLst>
          </p:cNvPr>
          <p:cNvSpPr txBox="1"/>
          <p:nvPr/>
        </p:nvSpPr>
        <p:spPr>
          <a:xfrm>
            <a:off x="5236043" y="5912673"/>
            <a:ext cx="1273524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69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+ 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56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dim 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NK cells</a:t>
            </a:r>
            <a:endParaRPr kumimoji="1" lang="ja-JP" alt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7F9D426-B87A-48D2-AC64-EEAAEFB75C14}"/>
              </a:ext>
            </a:extLst>
          </p:cNvPr>
          <p:cNvSpPr txBox="1"/>
          <p:nvPr/>
        </p:nvSpPr>
        <p:spPr>
          <a:xfrm>
            <a:off x="5236043" y="5353986"/>
            <a:ext cx="1334525" cy="430887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  <a:r>
              <a:rPr kumimoji="1" lang="en-US" altLang="ja-JP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56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bright 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NK cells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1FE1617-F8C2-45BC-BEE9-EB606305D068}"/>
              </a:ext>
            </a:extLst>
          </p:cNvPr>
          <p:cNvSpPr txBox="1"/>
          <p:nvPr/>
        </p:nvSpPr>
        <p:spPr>
          <a:xfrm>
            <a:off x="1563078" y="2444273"/>
            <a:ext cx="72151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122FBE5-94BB-44A3-A972-B178007D01ED}"/>
              </a:ext>
            </a:extLst>
          </p:cNvPr>
          <p:cNvSpPr txBox="1"/>
          <p:nvPr/>
        </p:nvSpPr>
        <p:spPr>
          <a:xfrm>
            <a:off x="3337659" y="2825878"/>
            <a:ext cx="1041688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anchor="t">
            <a:spAutoFit/>
          </a:bodyPr>
          <a:lstStyle/>
          <a:p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CD69</a:t>
            </a:r>
            <a:r>
              <a:rPr kumimoji="1" lang="en-US" altLang="ja-JP" sz="1100" baseline="30000" dirty="0">
                <a:latin typeface="Arial"/>
                <a:ea typeface="游ゴシック"/>
                <a:cs typeface="Arial"/>
              </a:rPr>
              <a:t>+ </a:t>
            </a:r>
            <a:r>
              <a:rPr kumimoji="1" lang="en-US" altLang="ja-JP" sz="1100" dirty="0">
                <a:latin typeface="Arial"/>
                <a:ea typeface="游ゴシック"/>
                <a:cs typeface="Arial"/>
              </a:rPr>
              <a:t>T cells</a:t>
            </a:r>
            <a:endParaRPr lang="ja-JP" altLang="en-US" sz="1100" dirty="0">
              <a:latin typeface="Arial"/>
              <a:ea typeface="游ゴシック"/>
              <a:cs typeface="Arial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C00F2C5-E75B-09EA-D342-0C1D519A1F3B}"/>
              </a:ext>
            </a:extLst>
          </p:cNvPr>
          <p:cNvSpPr/>
          <p:nvPr/>
        </p:nvSpPr>
        <p:spPr>
          <a:xfrm>
            <a:off x="1325011" y="2806700"/>
            <a:ext cx="433138" cy="319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63B22733-76F1-D0D7-82D0-6898BD35937A}"/>
              </a:ext>
            </a:extLst>
          </p:cNvPr>
          <p:cNvCxnSpPr>
            <a:cxnSpLocks/>
          </p:cNvCxnSpPr>
          <p:nvPr/>
        </p:nvCxnSpPr>
        <p:spPr>
          <a:xfrm>
            <a:off x="1764324" y="2966428"/>
            <a:ext cx="5754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図 20">
            <a:extLst>
              <a:ext uri="{FF2B5EF4-FFF2-40B4-BE49-F238E27FC236}">
                <a16:creationId xmlns:a16="http://schemas.microsoft.com/office/drawing/2014/main" id="{C8B2F9F3-9C44-D7B4-3981-940EE7DEBB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5973" y="273970"/>
            <a:ext cx="1462857" cy="1440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2CBC06DB-1C57-6F28-E30B-A545978195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28786" y="273970"/>
            <a:ext cx="1462857" cy="144000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6DD218D0-C193-D61D-17E1-B2206E1637F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91599" y="273970"/>
            <a:ext cx="1481143" cy="1440000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B2447314-ECF9-CD9E-1165-4B152C91139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572697" y="273970"/>
            <a:ext cx="1481143" cy="1440000"/>
          </a:xfrm>
          <a:prstGeom prst="rect">
            <a:avLst/>
          </a:prstGeom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7CF113D-02E5-A4D2-B872-690A3F4F8ED1}"/>
              </a:ext>
            </a:extLst>
          </p:cNvPr>
          <p:cNvSpPr txBox="1"/>
          <p:nvPr/>
        </p:nvSpPr>
        <p:spPr>
          <a:xfrm rot="16200000">
            <a:off x="44833" y="79680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959A53B-98ED-789B-4CFA-738FD8E76C56}"/>
              </a:ext>
            </a:extLst>
          </p:cNvPr>
          <p:cNvSpPr txBox="1"/>
          <p:nvPr/>
        </p:nvSpPr>
        <p:spPr>
          <a:xfrm>
            <a:off x="876854" y="1614343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1B8860F-D468-73A0-F8A4-979DE193F00E}"/>
              </a:ext>
            </a:extLst>
          </p:cNvPr>
          <p:cNvSpPr txBox="1"/>
          <p:nvPr/>
        </p:nvSpPr>
        <p:spPr>
          <a:xfrm>
            <a:off x="2848377" y="1614343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B9F39B6-BC7E-3246-6CD3-4F2CC088B324}"/>
              </a:ext>
            </a:extLst>
          </p:cNvPr>
          <p:cNvSpPr txBox="1"/>
          <p:nvPr/>
        </p:nvSpPr>
        <p:spPr>
          <a:xfrm rot="16200000">
            <a:off x="2008949" y="79680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AAD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FBA573A6-B2FA-1B34-B2C9-F164CE03098F}"/>
              </a:ext>
            </a:extLst>
          </p:cNvPr>
          <p:cNvSpPr txBox="1"/>
          <p:nvPr/>
        </p:nvSpPr>
        <p:spPr>
          <a:xfrm rot="16200000">
            <a:off x="3978646" y="79680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8C61551-33D7-E9E3-9300-229AD79CCEB5}"/>
              </a:ext>
            </a:extLst>
          </p:cNvPr>
          <p:cNvSpPr txBox="1"/>
          <p:nvPr/>
        </p:nvSpPr>
        <p:spPr>
          <a:xfrm>
            <a:off x="4827536" y="1614343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17A09E4-B089-D79D-53B5-ED8E41D76A84}"/>
              </a:ext>
            </a:extLst>
          </p:cNvPr>
          <p:cNvSpPr txBox="1"/>
          <p:nvPr/>
        </p:nvSpPr>
        <p:spPr>
          <a:xfrm rot="16200000">
            <a:off x="5958464" y="79680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SC-W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7D94DA4-E0F5-B302-3B4F-FFA066132F7D}"/>
              </a:ext>
            </a:extLst>
          </p:cNvPr>
          <p:cNvSpPr txBox="1"/>
          <p:nvPr/>
        </p:nvSpPr>
        <p:spPr>
          <a:xfrm>
            <a:off x="6814656" y="1614343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302198D8-06B2-552F-8505-DE40F8CAD8BC}"/>
              </a:ext>
            </a:extLst>
          </p:cNvPr>
          <p:cNvCxnSpPr>
            <a:cxnSpLocks/>
          </p:cNvCxnSpPr>
          <p:nvPr/>
        </p:nvCxnSpPr>
        <p:spPr>
          <a:xfrm>
            <a:off x="1524000" y="1047750"/>
            <a:ext cx="92541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071119E4-C179-87BA-AE91-D07B2CEA10ED}"/>
              </a:ext>
            </a:extLst>
          </p:cNvPr>
          <p:cNvCxnSpPr>
            <a:cxnSpLocks/>
          </p:cNvCxnSpPr>
          <p:nvPr/>
        </p:nvCxnSpPr>
        <p:spPr>
          <a:xfrm>
            <a:off x="3488393" y="1047750"/>
            <a:ext cx="92541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93B07FC2-22DC-524E-AC47-6765FF577FCF}"/>
              </a:ext>
            </a:extLst>
          </p:cNvPr>
          <p:cNvCxnSpPr>
            <a:cxnSpLocks/>
          </p:cNvCxnSpPr>
          <p:nvPr/>
        </p:nvCxnSpPr>
        <p:spPr>
          <a:xfrm>
            <a:off x="5476496" y="1047750"/>
            <a:ext cx="92541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76E7901-70F8-EFC7-AF36-7904A3441C3C}"/>
              </a:ext>
            </a:extLst>
          </p:cNvPr>
          <p:cNvSpPr txBox="1"/>
          <p:nvPr/>
        </p:nvSpPr>
        <p:spPr>
          <a:xfrm>
            <a:off x="5332170" y="699212"/>
            <a:ext cx="4109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7FAB935-2A3D-2CC2-9432-89AD4631C8E1}"/>
              </a:ext>
            </a:extLst>
          </p:cNvPr>
          <p:cNvSpPr txBox="1"/>
          <p:nvPr/>
        </p:nvSpPr>
        <p:spPr>
          <a:xfrm>
            <a:off x="7514087" y="645674"/>
            <a:ext cx="4109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CCD8B1A-7942-D803-2B63-9710E1D1CB50}"/>
              </a:ext>
            </a:extLst>
          </p:cNvPr>
          <p:cNvSpPr txBox="1"/>
          <p:nvPr/>
        </p:nvSpPr>
        <p:spPr>
          <a:xfrm>
            <a:off x="3616276" y="625955"/>
            <a:ext cx="4109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7E1CD2-DB2C-0B69-28CA-3EB0AD068CA4}"/>
              </a:ext>
            </a:extLst>
          </p:cNvPr>
          <p:cNvSpPr txBox="1"/>
          <p:nvPr/>
        </p:nvSpPr>
        <p:spPr>
          <a:xfrm>
            <a:off x="1563078" y="1138461"/>
            <a:ext cx="4109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E0D806CB-1EBD-EFAC-F1C1-62819A9090A2}"/>
              </a:ext>
            </a:extLst>
          </p:cNvPr>
          <p:cNvCxnSpPr>
            <a:cxnSpLocks/>
          </p:cNvCxnSpPr>
          <p:nvPr/>
        </p:nvCxnSpPr>
        <p:spPr>
          <a:xfrm>
            <a:off x="7646509" y="1025492"/>
            <a:ext cx="92541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7D0922D-BC0C-E315-2392-2B94D2FD7AE8}"/>
              </a:ext>
            </a:extLst>
          </p:cNvPr>
          <p:cNvSpPr txBox="1"/>
          <p:nvPr/>
        </p:nvSpPr>
        <p:spPr>
          <a:xfrm>
            <a:off x="946005" y="3232654"/>
            <a:ext cx="115086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EFE8346-E940-9C17-BED4-CE42C2F2D7A3}"/>
              </a:ext>
            </a:extLst>
          </p:cNvPr>
          <p:cNvSpPr txBox="1"/>
          <p:nvPr/>
        </p:nvSpPr>
        <p:spPr>
          <a:xfrm rot="16200000">
            <a:off x="47087" y="4075680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kumimoji="1" lang="en-US" altLang="ja-JP" sz="1200" dirty="0">
                <a:latin typeface="Arial"/>
                <a:ea typeface="游ゴシック"/>
                <a:cs typeface="Arial"/>
              </a:rPr>
              <a:t>CD56</a:t>
            </a:r>
            <a:endParaRPr lang="ja-JP" altLang="en-US" sz="1200">
              <a:latin typeface="Arial"/>
              <a:ea typeface="游ゴシック"/>
              <a:cs typeface="Arial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3367924-EDC1-9258-1FFE-F6673A6A7601}"/>
              </a:ext>
            </a:extLst>
          </p:cNvPr>
          <p:cNvSpPr txBox="1"/>
          <p:nvPr/>
        </p:nvSpPr>
        <p:spPr>
          <a:xfrm rot="16200000">
            <a:off x="47086" y="5750855"/>
            <a:ext cx="129456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64BB42FB-6394-110B-D961-0BDC69A080EF}"/>
              </a:ext>
            </a:extLst>
          </p:cNvPr>
          <p:cNvSpPr/>
          <p:nvPr/>
        </p:nvSpPr>
        <p:spPr>
          <a:xfrm>
            <a:off x="1327058" y="4167230"/>
            <a:ext cx="433138" cy="319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0BCE1877-6EA5-4F7A-C11C-A9054EB29E71}"/>
              </a:ext>
            </a:extLst>
          </p:cNvPr>
          <p:cNvSpPr/>
          <p:nvPr/>
        </p:nvSpPr>
        <p:spPr>
          <a:xfrm>
            <a:off x="964262" y="5597625"/>
            <a:ext cx="369237" cy="5068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ja-JP" altLang="en-US" dirty="0">
              <a:latin typeface="Arial"/>
              <a:cs typeface="Arial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02DD7BDB-C9E4-1CA9-CC42-4A8D14ADDC1D}"/>
              </a:ext>
            </a:extLst>
          </p:cNvPr>
          <p:cNvSpPr txBox="1"/>
          <p:nvPr/>
        </p:nvSpPr>
        <p:spPr>
          <a:xfrm>
            <a:off x="1148880" y="3806651"/>
            <a:ext cx="8461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KT cell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F9D4B04-F2F3-DEA8-59BD-2897C8E27FA6}"/>
              </a:ext>
            </a:extLst>
          </p:cNvPr>
          <p:cNvSpPr txBox="1"/>
          <p:nvPr/>
        </p:nvSpPr>
        <p:spPr>
          <a:xfrm>
            <a:off x="912002" y="5329975"/>
            <a:ext cx="8461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K cell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CC95587C-E585-62E9-8747-22B39509BEB6}"/>
              </a:ext>
            </a:extLst>
          </p:cNvPr>
          <p:cNvCxnSpPr>
            <a:cxnSpLocks/>
          </p:cNvCxnSpPr>
          <p:nvPr/>
        </p:nvCxnSpPr>
        <p:spPr>
          <a:xfrm>
            <a:off x="4575126" y="5846429"/>
            <a:ext cx="117760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8F016C6-6F63-0D14-5A29-6DB01153893B}"/>
              </a:ext>
            </a:extLst>
          </p:cNvPr>
          <p:cNvSpPr txBox="1"/>
          <p:nvPr/>
        </p:nvSpPr>
        <p:spPr>
          <a:xfrm>
            <a:off x="2738978" y="6584030"/>
            <a:ext cx="115086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BF9E2217-644C-082C-AF20-3DD4E994FFCD}"/>
              </a:ext>
            </a:extLst>
          </p:cNvPr>
          <p:cNvCxnSpPr>
            <a:cxnSpLocks/>
          </p:cNvCxnSpPr>
          <p:nvPr/>
        </p:nvCxnSpPr>
        <p:spPr>
          <a:xfrm>
            <a:off x="1333499" y="5913762"/>
            <a:ext cx="95109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BE05A7D4-D5ED-848E-B576-0BF70AB8E38D}"/>
              </a:ext>
            </a:extLst>
          </p:cNvPr>
          <p:cNvCxnSpPr>
            <a:cxnSpLocks/>
          </p:cNvCxnSpPr>
          <p:nvPr/>
        </p:nvCxnSpPr>
        <p:spPr>
          <a:xfrm>
            <a:off x="1325011" y="6308386"/>
            <a:ext cx="30543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7D45DE5-A57F-68D8-A6BF-91BE67FF689D}"/>
              </a:ext>
            </a:extLst>
          </p:cNvPr>
          <p:cNvCxnSpPr>
            <a:cxnSpLocks/>
          </p:cNvCxnSpPr>
          <p:nvPr/>
        </p:nvCxnSpPr>
        <p:spPr>
          <a:xfrm>
            <a:off x="1322914" y="6104466"/>
            <a:ext cx="0" cy="2039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A1F331C-4FAD-E3DD-B164-4F72297F9B15}"/>
              </a:ext>
            </a:extLst>
          </p:cNvPr>
          <p:cNvSpPr txBox="1"/>
          <p:nvPr/>
        </p:nvSpPr>
        <p:spPr>
          <a:xfrm>
            <a:off x="184092" y="1902972"/>
            <a:ext cx="30540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a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6F6790B-F0E2-FB69-EE6F-D9316F095EA8}"/>
              </a:ext>
            </a:extLst>
          </p:cNvPr>
          <p:cNvSpPr txBox="1"/>
          <p:nvPr/>
        </p:nvSpPr>
        <p:spPr>
          <a:xfrm>
            <a:off x="184092" y="5253858"/>
            <a:ext cx="2632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c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780783F-F40C-B950-5914-05E9548F742D}"/>
              </a:ext>
            </a:extLst>
          </p:cNvPr>
          <p:cNvSpPr txBox="1"/>
          <p:nvPr/>
        </p:nvSpPr>
        <p:spPr>
          <a:xfrm>
            <a:off x="184092" y="3578415"/>
            <a:ext cx="305406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kumimoji="1" lang="en-US" altLang="ja-JP" dirty="0">
                <a:latin typeface="Arial"/>
                <a:ea typeface="游ゴシック"/>
                <a:cs typeface="Times New Roman"/>
              </a:rPr>
              <a:t>b</a:t>
            </a:r>
            <a:endParaRPr lang="ja-JP" altLang="en-US">
              <a:latin typeface="Arial"/>
              <a:ea typeface="游ゴシック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37564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</TotalTime>
  <Words>87</Words>
  <Application>Microsoft Office PowerPoint</Application>
  <PresentationFormat>画面に合わせる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rgery today figure</dc:title>
  <dc:creator>emichikuie@outlook.jp</dc:creator>
  <cp:lastModifiedBy>築家　恵美</cp:lastModifiedBy>
  <cp:revision>74</cp:revision>
  <dcterms:created xsi:type="dcterms:W3CDTF">2021-09-12T14:20:25Z</dcterms:created>
  <dcterms:modified xsi:type="dcterms:W3CDTF">2023-08-05T06:00:39Z</dcterms:modified>
</cp:coreProperties>
</file>